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V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/>
    <p:restoredTop sz="94648"/>
  </p:normalViewPr>
  <p:slideViewPr>
    <p:cSldViewPr snapToGrid="0">
      <p:cViewPr>
        <p:scale>
          <a:sx n="103" d="100"/>
          <a:sy n="103" d="100"/>
        </p:scale>
        <p:origin x="800" y="1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8D9FED-2355-3EC3-0753-008C5A883E5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A9EA40C-C98E-90B4-43CF-A7649C9EF7B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43C26F-C9AE-4199-76F4-85136DEF1A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CFCB7-94D0-C14A-A107-A84214FBDBFA}" type="datetimeFigureOut">
              <a:rPr lang="en-VN" smtClean="0"/>
              <a:t>16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57F005-F30D-3799-362E-FEF38EE46C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8D38B9-ED5B-5F2B-6D90-A4ECE5AE7E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88124-AFD7-2E40-A3D6-BF7355417553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13704725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0796FF-CD07-A15E-87E2-FC6BD7E564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D36D588-0368-EE35-9621-88FCB9186B0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06F5C7-E15D-3FFB-529A-927B6DFD34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CFCB7-94D0-C14A-A107-A84214FBDBFA}" type="datetimeFigureOut">
              <a:rPr lang="en-VN" smtClean="0"/>
              <a:t>16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2086977-2E92-0DF5-36EB-DE955A50C0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079C3F-885C-0D18-DAF0-FFA5A0C2AD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88124-AFD7-2E40-A3D6-BF7355417553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22021635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7E5431D-DE1E-785B-7BCA-8A242A9AD52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BA12768-BF16-1AB0-7D89-51241363B9C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5931B3-ACC8-AB35-C625-322F32C8EE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CFCB7-94D0-C14A-A107-A84214FBDBFA}" type="datetimeFigureOut">
              <a:rPr lang="en-VN" smtClean="0"/>
              <a:t>16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7F66EE-FEAE-FCB7-EF7C-1E0C2D65B7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0A589C-A90B-F398-0677-6636ED428D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88124-AFD7-2E40-A3D6-BF7355417553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24677154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8E9C9F-5888-B52A-C1B0-93D3E91A6A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ABF0A28-437C-FFF7-55BE-A9F16566CB0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E0B52F-15EB-1AFA-5A9A-E641A44903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CFCB7-94D0-C14A-A107-A84214FBDBFA}" type="datetimeFigureOut">
              <a:rPr lang="en-VN" smtClean="0"/>
              <a:t>16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7E1CFC-2441-20E2-298D-882C7C4838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886C74-DB97-FFD9-A577-8C73FB416F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88124-AFD7-2E40-A3D6-BF7355417553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28089824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5ECEF7-82E2-F671-D9B2-86F441BFEC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957C803-43E0-4E6E-4996-DDDAA5CCA7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BFC5FA-7B09-ED7A-D38F-E5BC0BB321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CFCB7-94D0-C14A-A107-A84214FBDBFA}" type="datetimeFigureOut">
              <a:rPr lang="en-VN" smtClean="0"/>
              <a:t>16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C0331A-3301-9856-DCBF-E4BE8083DE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FE9EA2-91F9-7FE6-3824-D4A4CC1CCA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88124-AFD7-2E40-A3D6-BF7355417553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41927344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0F0C3E-7186-DE94-6F12-DC572EFDE1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75B0215-766E-F070-BC09-A4B1FBED1D6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49AEB17-ABA7-77AB-7857-A3371A9C67D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F22A0F8-E566-C7C3-6119-629B9C70F4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CFCB7-94D0-C14A-A107-A84214FBDBFA}" type="datetimeFigureOut">
              <a:rPr lang="en-VN" smtClean="0"/>
              <a:t>16/05/2024</a:t>
            </a:fld>
            <a:endParaRPr lang="en-V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80CBB6A-98A2-B06D-D992-95A02EF5A6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78CF0F6-FD6F-662D-D89C-26A3CD820F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88124-AFD7-2E40-A3D6-BF7355417553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27981424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76DCDA-E21F-2713-C28F-18C8AB0E00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CF6E71B-9FD8-88B7-3CEF-2BD58436E2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8DFBB3A-ADB8-1546-0701-E3106485812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F896C31-BBA7-5563-43EB-A0565CC4E08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E27A5A0-2604-0CEC-27F4-82E2BF9268B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DCE6DA9-1020-B616-2D53-59EB11FEAA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CFCB7-94D0-C14A-A107-A84214FBDBFA}" type="datetimeFigureOut">
              <a:rPr lang="en-VN" smtClean="0"/>
              <a:t>16/05/2024</a:t>
            </a:fld>
            <a:endParaRPr lang="en-V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6F0E9F7-E4A0-D790-FFA5-4ABFF9B240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500B781-F999-7CB4-9FB9-1C61918CF7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88124-AFD7-2E40-A3D6-BF7355417553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22608116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60544E-C2B5-A835-4D55-EF1A82A903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3E68724-8FD4-94F8-EB2A-EAFB8822B5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CFCB7-94D0-C14A-A107-A84214FBDBFA}" type="datetimeFigureOut">
              <a:rPr lang="en-VN" smtClean="0"/>
              <a:t>16/05/2024</a:t>
            </a:fld>
            <a:endParaRPr lang="en-V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BF6CB9C-1384-2F91-3748-FF83CF6BEA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75C852C-4AEC-3FF5-8F48-0B26F5ACA7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88124-AFD7-2E40-A3D6-BF7355417553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7915840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D7C873D-31D8-C3C8-2DDC-86C554C2A5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CFCB7-94D0-C14A-A107-A84214FBDBFA}" type="datetimeFigureOut">
              <a:rPr lang="en-VN" smtClean="0"/>
              <a:t>16/05/2024</a:t>
            </a:fld>
            <a:endParaRPr lang="en-V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E0FA568-1948-D138-DE94-D7DD20AA21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556954B-682C-A8E4-B236-13A3F7961B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88124-AFD7-2E40-A3D6-BF7355417553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1220723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D4F1EF-7836-68B2-06AC-E5660CB32C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C0BED20-8175-F5FD-12A8-B3EC087990C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F79B924-4E23-AF61-E5A7-4B5D7C438FE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BAA9BA3-6E17-743A-C2F2-4519601B42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CFCB7-94D0-C14A-A107-A84214FBDBFA}" type="datetimeFigureOut">
              <a:rPr lang="en-VN" smtClean="0"/>
              <a:t>16/05/2024</a:t>
            </a:fld>
            <a:endParaRPr lang="en-V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E3FD2FD-D29C-EAFB-5448-5B4448056C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9157B25-4AB4-EB1C-A13D-47835B60F3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88124-AFD7-2E40-A3D6-BF7355417553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6624919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91613A-535B-07EC-103F-F10B791C45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8861A9D-6662-25AD-C1C6-38187D162F0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C94D670-8EF0-0630-927D-F4D980878A0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91FE034-2950-978A-46F8-D3A0AAF776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CFCB7-94D0-C14A-A107-A84214FBDBFA}" type="datetimeFigureOut">
              <a:rPr lang="en-VN" smtClean="0"/>
              <a:t>16/05/2024</a:t>
            </a:fld>
            <a:endParaRPr lang="en-V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02E6401-AB97-0C97-8327-2A74AC733B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FDDB7B1-22EC-DDB5-C1B9-6C6641DB63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88124-AFD7-2E40-A3D6-BF7355417553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16730337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2F403C5-5EF9-4862-696E-EF557BBC5E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C081EFA-3BA0-498A-505A-29C92B2711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BCFEF06-9AF7-9DBF-B3B2-F38378FA7A9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88CFCB7-94D0-C14A-A107-A84214FBDBFA}" type="datetimeFigureOut">
              <a:rPr lang="en-VN" smtClean="0"/>
              <a:t>16/05/2024</a:t>
            </a:fld>
            <a:endParaRPr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68F0F5-3B61-2950-6E7E-710DD3E1E48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B510DA-6C09-B483-1EB6-94DA47ECCD9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4C88124-AFD7-2E40-A3D6-BF7355417553}" type="slidenum">
              <a:rPr lang="en-VN" smtClean="0"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38706463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V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1110D0B7-0B42-D58D-86CB-450073E2281A}"/>
              </a:ext>
            </a:extLst>
          </p:cNvPr>
          <p:cNvSpPr txBox="1"/>
          <p:nvPr/>
        </p:nvSpPr>
        <p:spPr>
          <a:xfrm>
            <a:off x="579555" y="1369369"/>
            <a:ext cx="20313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CHX 50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g/ml		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D272DA9-8BF8-1A46-A0EB-A5BFBA57C4BC}"/>
              </a:ext>
            </a:extLst>
          </p:cNvPr>
          <p:cNvSpPr txBox="1"/>
          <p:nvPr/>
        </p:nvSpPr>
        <p:spPr>
          <a:xfrm>
            <a:off x="313768" y="1700074"/>
            <a:ext cx="29546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MG132 20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g/ml		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700D2BD-51F0-57D2-421A-B90344D7C7B6}"/>
              </a:ext>
            </a:extLst>
          </p:cNvPr>
          <p:cNvSpPr txBox="1"/>
          <p:nvPr/>
        </p:nvSpPr>
        <p:spPr>
          <a:xfrm>
            <a:off x="266876" y="2025527"/>
            <a:ext cx="29546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Baf-A1 0.2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g/ml		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931B5AE2-2B2A-B882-8406-3FDCBD21F371}"/>
              </a:ext>
            </a:extLst>
          </p:cNvPr>
          <p:cNvCxnSpPr>
            <a:cxnSpLocks/>
          </p:cNvCxnSpPr>
          <p:nvPr/>
        </p:nvCxnSpPr>
        <p:spPr>
          <a:xfrm>
            <a:off x="1138879" y="1273827"/>
            <a:ext cx="387716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Rectangle 11">
            <a:extLst>
              <a:ext uri="{FF2B5EF4-FFF2-40B4-BE49-F238E27FC236}">
                <a16:creationId xmlns:a16="http://schemas.microsoft.com/office/drawing/2014/main" id="{EB1BC824-01E0-D506-2977-31884F587956}"/>
              </a:ext>
            </a:extLst>
          </p:cNvPr>
          <p:cNvSpPr/>
          <p:nvPr/>
        </p:nvSpPr>
        <p:spPr>
          <a:xfrm>
            <a:off x="3350313" y="911422"/>
            <a:ext cx="76723" cy="88229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02914DE5-D344-954F-DA15-C915B746E05F}"/>
              </a:ext>
            </a:extLst>
          </p:cNvPr>
          <p:cNvSpPr/>
          <p:nvPr/>
        </p:nvSpPr>
        <p:spPr>
          <a:xfrm>
            <a:off x="4652033" y="924455"/>
            <a:ext cx="76723" cy="88229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2709E68-0ECA-ED0B-D4DB-566ADD46D1B8}"/>
              </a:ext>
            </a:extLst>
          </p:cNvPr>
          <p:cNvSpPr txBox="1"/>
          <p:nvPr/>
        </p:nvSpPr>
        <p:spPr>
          <a:xfrm>
            <a:off x="4676495" y="1680738"/>
            <a:ext cx="6527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3hours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B7520DB-D051-7D59-3BA6-9AA2DA2A852A}"/>
              </a:ext>
            </a:extLst>
          </p:cNvPr>
          <p:cNvSpPr txBox="1"/>
          <p:nvPr/>
        </p:nvSpPr>
        <p:spPr>
          <a:xfrm>
            <a:off x="4676495" y="2040791"/>
            <a:ext cx="6527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3hours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DABACF6-D2A9-ED4A-0780-D1A342E64F7B}"/>
              </a:ext>
            </a:extLst>
          </p:cNvPr>
          <p:cNvSpPr txBox="1"/>
          <p:nvPr/>
        </p:nvSpPr>
        <p:spPr>
          <a:xfrm>
            <a:off x="4680934" y="1343713"/>
            <a:ext cx="6527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3hours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5685093D-FE7E-78E3-1414-DF79BE3FA094}"/>
              </a:ext>
            </a:extLst>
          </p:cNvPr>
          <p:cNvSpPr/>
          <p:nvPr/>
        </p:nvSpPr>
        <p:spPr>
          <a:xfrm>
            <a:off x="733735" y="887968"/>
            <a:ext cx="179288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Dox (µg/ml)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D0192D9D-2C31-4674-2873-9FC4C1B7A930}"/>
              </a:ext>
            </a:extLst>
          </p:cNvPr>
          <p:cNvSpPr txBox="1"/>
          <p:nvPr/>
        </p:nvSpPr>
        <p:spPr>
          <a:xfrm>
            <a:off x="726958" y="562515"/>
            <a:ext cx="104952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MITF</a:t>
            </a:r>
            <a:endParaRPr lang="en-GB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EB71B56-6A17-D8A6-62ED-710CB1217FBF}"/>
              </a:ext>
            </a:extLst>
          </p:cNvPr>
          <p:cNvSpPr txBox="1"/>
          <p:nvPr/>
        </p:nvSpPr>
        <p:spPr>
          <a:xfrm>
            <a:off x="1798287" y="602677"/>
            <a:ext cx="383441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EV          WT             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                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FCB9CE12-F968-72CD-A1C2-8F6DE35C196F}"/>
              </a:ext>
            </a:extLst>
          </p:cNvPr>
          <p:cNvSpPr/>
          <p:nvPr/>
        </p:nvSpPr>
        <p:spPr>
          <a:xfrm>
            <a:off x="2203590" y="885054"/>
            <a:ext cx="3834418" cy="2836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     0.1              0.1                  1           (24hours)</a:t>
            </a:r>
          </a:p>
        </p:txBody>
      </p:sp>
      <p:pic>
        <p:nvPicPr>
          <p:cNvPr id="35" name="Picture 34">
            <a:extLst>
              <a:ext uri="{FF2B5EF4-FFF2-40B4-BE49-F238E27FC236}">
                <a16:creationId xmlns:a16="http://schemas.microsoft.com/office/drawing/2014/main" id="{7415AAAA-8348-E90D-8E28-5A7C0C234BA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06532" y="2336603"/>
            <a:ext cx="4064137" cy="2961136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944DA46B-AA78-5490-8797-EB75AE2EAE4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17130" y="2371441"/>
            <a:ext cx="4064136" cy="2961135"/>
          </a:xfrm>
          <a:prstGeom prst="rect">
            <a:avLst/>
          </a:prstGeom>
        </p:spPr>
      </p:pic>
      <p:sp>
        <p:nvSpPr>
          <p:cNvPr id="38" name="TextBox 37">
            <a:extLst>
              <a:ext uri="{FF2B5EF4-FFF2-40B4-BE49-F238E27FC236}">
                <a16:creationId xmlns:a16="http://schemas.microsoft.com/office/drawing/2014/main" id="{FE6126E9-F007-0AF1-3857-7A6F75322E11}"/>
              </a:ext>
            </a:extLst>
          </p:cNvPr>
          <p:cNvSpPr txBox="1"/>
          <p:nvPr/>
        </p:nvSpPr>
        <p:spPr>
          <a:xfrm>
            <a:off x="238858" y="3058663"/>
            <a:ext cx="13840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065BD2D6-4A11-088E-FE2C-637130B7D4F2}"/>
              </a:ext>
            </a:extLst>
          </p:cNvPr>
          <p:cNvSpPr txBox="1"/>
          <p:nvPr/>
        </p:nvSpPr>
        <p:spPr>
          <a:xfrm>
            <a:off x="275676" y="3682188"/>
            <a:ext cx="12077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E957A1DE-17F6-EEAA-BC1E-21B75B1253E9}"/>
              </a:ext>
            </a:extLst>
          </p:cNvPr>
          <p:cNvSpPr txBox="1"/>
          <p:nvPr/>
        </p:nvSpPr>
        <p:spPr>
          <a:xfrm>
            <a:off x="309060" y="4031795"/>
            <a:ext cx="11409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0308BC78-B3CD-D1F7-6806-34AE3D13ECF7}"/>
              </a:ext>
            </a:extLst>
          </p:cNvPr>
          <p:cNvSpPr txBox="1"/>
          <p:nvPr/>
        </p:nvSpPr>
        <p:spPr>
          <a:xfrm>
            <a:off x="3702879" y="4615875"/>
            <a:ext cx="697627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8FAC42A7-C7E6-A888-9D4E-04D861CF4F8A}"/>
              </a:ext>
            </a:extLst>
          </p:cNvPr>
          <p:cNvSpPr/>
          <p:nvPr/>
        </p:nvSpPr>
        <p:spPr>
          <a:xfrm>
            <a:off x="2260276" y="3978029"/>
            <a:ext cx="2510393" cy="499311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AC31BD8E-A778-D374-5795-7CC13953E657}"/>
              </a:ext>
            </a:extLst>
          </p:cNvPr>
          <p:cNvSpPr txBox="1"/>
          <p:nvPr/>
        </p:nvSpPr>
        <p:spPr>
          <a:xfrm>
            <a:off x="262260" y="4438372"/>
            <a:ext cx="11409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9DA7432E-0F3E-08D5-3E61-E93E480CDB17}"/>
              </a:ext>
            </a:extLst>
          </p:cNvPr>
          <p:cNvSpPr txBox="1"/>
          <p:nvPr/>
        </p:nvSpPr>
        <p:spPr>
          <a:xfrm>
            <a:off x="262260" y="2784354"/>
            <a:ext cx="13840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4BD5D795-B60E-064D-7591-D1B43FA402E9}"/>
              </a:ext>
            </a:extLst>
          </p:cNvPr>
          <p:cNvSpPr txBox="1"/>
          <p:nvPr/>
        </p:nvSpPr>
        <p:spPr>
          <a:xfrm>
            <a:off x="262261" y="2533980"/>
            <a:ext cx="13840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9" name="Table 37">
            <a:extLst>
              <a:ext uri="{FF2B5EF4-FFF2-40B4-BE49-F238E27FC236}">
                <a16:creationId xmlns:a16="http://schemas.microsoft.com/office/drawing/2014/main" id="{22297FC5-AAF0-D550-BFC0-CCF9C88E90A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87155822"/>
              </p:ext>
            </p:extLst>
          </p:nvPr>
        </p:nvGraphicFramePr>
        <p:xfrm>
          <a:off x="2260276" y="1365601"/>
          <a:ext cx="797238" cy="10058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29132">
                  <a:extLst>
                    <a:ext uri="{9D8B030D-6E8A-4147-A177-3AD203B41FA5}">
                      <a16:colId xmlns:a16="http://schemas.microsoft.com/office/drawing/2014/main" val="2196274505"/>
                    </a:ext>
                  </a:extLst>
                </a:gridCol>
                <a:gridCol w="284053">
                  <a:extLst>
                    <a:ext uri="{9D8B030D-6E8A-4147-A177-3AD203B41FA5}">
                      <a16:colId xmlns:a16="http://schemas.microsoft.com/office/drawing/2014/main" val="2410484320"/>
                    </a:ext>
                  </a:extLst>
                </a:gridCol>
                <a:gridCol w="284053">
                  <a:extLst>
                    <a:ext uri="{9D8B030D-6E8A-4147-A177-3AD203B41FA5}">
                      <a16:colId xmlns:a16="http://schemas.microsoft.com/office/drawing/2014/main" val="2310628921"/>
                    </a:ext>
                  </a:extLst>
                </a:gridCol>
              </a:tblGrid>
              <a:tr h="17722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11382016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5747769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37971763"/>
                  </a:ext>
                </a:extLst>
              </a:tr>
            </a:tbl>
          </a:graphicData>
        </a:graphic>
      </p:graphicFrame>
      <p:graphicFrame>
        <p:nvGraphicFramePr>
          <p:cNvPr id="50" name="Table 37">
            <a:extLst>
              <a:ext uri="{FF2B5EF4-FFF2-40B4-BE49-F238E27FC236}">
                <a16:creationId xmlns:a16="http://schemas.microsoft.com/office/drawing/2014/main" id="{EABAB6B3-DF36-36A1-C740-186CF846BA2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0080127"/>
              </p:ext>
            </p:extLst>
          </p:nvPr>
        </p:nvGraphicFramePr>
        <p:xfrm>
          <a:off x="3094356" y="1356134"/>
          <a:ext cx="797238" cy="10058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29132">
                  <a:extLst>
                    <a:ext uri="{9D8B030D-6E8A-4147-A177-3AD203B41FA5}">
                      <a16:colId xmlns:a16="http://schemas.microsoft.com/office/drawing/2014/main" val="2196274505"/>
                    </a:ext>
                  </a:extLst>
                </a:gridCol>
                <a:gridCol w="284053">
                  <a:extLst>
                    <a:ext uri="{9D8B030D-6E8A-4147-A177-3AD203B41FA5}">
                      <a16:colId xmlns:a16="http://schemas.microsoft.com/office/drawing/2014/main" val="2410484320"/>
                    </a:ext>
                  </a:extLst>
                </a:gridCol>
                <a:gridCol w="284053">
                  <a:extLst>
                    <a:ext uri="{9D8B030D-6E8A-4147-A177-3AD203B41FA5}">
                      <a16:colId xmlns:a16="http://schemas.microsoft.com/office/drawing/2014/main" val="2310628921"/>
                    </a:ext>
                  </a:extLst>
                </a:gridCol>
              </a:tblGrid>
              <a:tr h="17722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11382016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5747769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37971763"/>
                  </a:ext>
                </a:extLst>
              </a:tr>
            </a:tbl>
          </a:graphicData>
        </a:graphic>
      </p:graphicFrame>
      <p:graphicFrame>
        <p:nvGraphicFramePr>
          <p:cNvPr id="51" name="Table 37">
            <a:extLst>
              <a:ext uri="{FF2B5EF4-FFF2-40B4-BE49-F238E27FC236}">
                <a16:creationId xmlns:a16="http://schemas.microsoft.com/office/drawing/2014/main" id="{86160438-19DD-0E9B-B422-4123652F4CF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09818528"/>
              </p:ext>
            </p:extLst>
          </p:nvPr>
        </p:nvGraphicFramePr>
        <p:xfrm>
          <a:off x="3896030" y="1345882"/>
          <a:ext cx="797238" cy="10058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29132">
                  <a:extLst>
                    <a:ext uri="{9D8B030D-6E8A-4147-A177-3AD203B41FA5}">
                      <a16:colId xmlns:a16="http://schemas.microsoft.com/office/drawing/2014/main" val="2196274505"/>
                    </a:ext>
                  </a:extLst>
                </a:gridCol>
                <a:gridCol w="284053">
                  <a:extLst>
                    <a:ext uri="{9D8B030D-6E8A-4147-A177-3AD203B41FA5}">
                      <a16:colId xmlns:a16="http://schemas.microsoft.com/office/drawing/2014/main" val="2410484320"/>
                    </a:ext>
                  </a:extLst>
                </a:gridCol>
                <a:gridCol w="284053">
                  <a:extLst>
                    <a:ext uri="{9D8B030D-6E8A-4147-A177-3AD203B41FA5}">
                      <a16:colId xmlns:a16="http://schemas.microsoft.com/office/drawing/2014/main" val="2310628921"/>
                    </a:ext>
                  </a:extLst>
                </a:gridCol>
              </a:tblGrid>
              <a:tr h="17722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11382016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5747769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37971763"/>
                  </a:ext>
                </a:extLst>
              </a:tr>
            </a:tbl>
          </a:graphicData>
        </a:graphic>
      </p:graphicFrame>
      <p:sp>
        <p:nvSpPr>
          <p:cNvPr id="52" name="TextBox 51">
            <a:extLst>
              <a:ext uri="{FF2B5EF4-FFF2-40B4-BE49-F238E27FC236}">
                <a16:creationId xmlns:a16="http://schemas.microsoft.com/office/drawing/2014/main" id="{368E8958-1F39-8C00-1D3D-358C0CF5DBFA}"/>
              </a:ext>
            </a:extLst>
          </p:cNvPr>
          <p:cNvSpPr txBox="1"/>
          <p:nvPr/>
        </p:nvSpPr>
        <p:spPr>
          <a:xfrm>
            <a:off x="6302820" y="1468052"/>
            <a:ext cx="20313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CHX 50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g/ml		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AAD2377D-5205-6EA5-DE2D-75F4D885EDBF}"/>
              </a:ext>
            </a:extLst>
          </p:cNvPr>
          <p:cNvSpPr txBox="1"/>
          <p:nvPr/>
        </p:nvSpPr>
        <p:spPr>
          <a:xfrm>
            <a:off x="6037033" y="1798757"/>
            <a:ext cx="29546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MG132 20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g/ml		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40342531-0C23-62A5-F61D-5E7055892A68}"/>
              </a:ext>
            </a:extLst>
          </p:cNvPr>
          <p:cNvSpPr txBox="1"/>
          <p:nvPr/>
        </p:nvSpPr>
        <p:spPr>
          <a:xfrm>
            <a:off x="5990141" y="2124210"/>
            <a:ext cx="29546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Baf-A1 0.2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g/ml		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D3A2E06B-396E-82E2-C55B-9776FCC9238E}"/>
              </a:ext>
            </a:extLst>
          </p:cNvPr>
          <p:cNvCxnSpPr>
            <a:cxnSpLocks/>
          </p:cNvCxnSpPr>
          <p:nvPr/>
        </p:nvCxnSpPr>
        <p:spPr>
          <a:xfrm>
            <a:off x="6862144" y="1372510"/>
            <a:ext cx="387716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Rectangle 55">
            <a:extLst>
              <a:ext uri="{FF2B5EF4-FFF2-40B4-BE49-F238E27FC236}">
                <a16:creationId xmlns:a16="http://schemas.microsoft.com/office/drawing/2014/main" id="{3FE32EBA-4FB5-5949-8936-FC76442A0A5C}"/>
              </a:ext>
            </a:extLst>
          </p:cNvPr>
          <p:cNvSpPr/>
          <p:nvPr/>
        </p:nvSpPr>
        <p:spPr>
          <a:xfrm>
            <a:off x="9073578" y="1010105"/>
            <a:ext cx="76723" cy="88229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E613FE7F-CA96-FEF9-5A7C-A526E8E04433}"/>
              </a:ext>
            </a:extLst>
          </p:cNvPr>
          <p:cNvSpPr/>
          <p:nvPr/>
        </p:nvSpPr>
        <p:spPr>
          <a:xfrm>
            <a:off x="10375298" y="1023138"/>
            <a:ext cx="76723" cy="88229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9DCF16CE-7F1B-1EA5-48B9-91032443AFDE}"/>
              </a:ext>
            </a:extLst>
          </p:cNvPr>
          <p:cNvSpPr txBox="1"/>
          <p:nvPr/>
        </p:nvSpPr>
        <p:spPr>
          <a:xfrm>
            <a:off x="10399760" y="1779421"/>
            <a:ext cx="6527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3hours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85DF00EF-90E6-75A1-81D5-6705E5B45B73}"/>
              </a:ext>
            </a:extLst>
          </p:cNvPr>
          <p:cNvSpPr txBox="1"/>
          <p:nvPr/>
        </p:nvSpPr>
        <p:spPr>
          <a:xfrm>
            <a:off x="10399760" y="2139474"/>
            <a:ext cx="6527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3hours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4FB83273-6C22-ABB5-4A91-B4AD8F31026B}"/>
              </a:ext>
            </a:extLst>
          </p:cNvPr>
          <p:cNvSpPr txBox="1"/>
          <p:nvPr/>
        </p:nvSpPr>
        <p:spPr>
          <a:xfrm>
            <a:off x="10404199" y="1442396"/>
            <a:ext cx="6527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3hours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41C81D5F-5C0E-DD6A-C78B-62BDEE30128B}"/>
              </a:ext>
            </a:extLst>
          </p:cNvPr>
          <p:cNvSpPr/>
          <p:nvPr/>
        </p:nvSpPr>
        <p:spPr>
          <a:xfrm>
            <a:off x="6457000" y="986651"/>
            <a:ext cx="179288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Dox (µg/ml)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74CE371A-A7B8-E9B1-8F8B-1C393A58B6E9}"/>
              </a:ext>
            </a:extLst>
          </p:cNvPr>
          <p:cNvSpPr txBox="1"/>
          <p:nvPr/>
        </p:nvSpPr>
        <p:spPr>
          <a:xfrm>
            <a:off x="6450223" y="661198"/>
            <a:ext cx="104952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MITF</a:t>
            </a:r>
            <a:endParaRPr lang="en-GB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59E18CE4-D1B3-4A9F-B4CD-46E38497B24F}"/>
              </a:ext>
            </a:extLst>
          </p:cNvPr>
          <p:cNvSpPr txBox="1"/>
          <p:nvPr/>
        </p:nvSpPr>
        <p:spPr>
          <a:xfrm>
            <a:off x="7521552" y="701360"/>
            <a:ext cx="383441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EV          WT             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                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Rectangle 63">
            <a:extLst>
              <a:ext uri="{FF2B5EF4-FFF2-40B4-BE49-F238E27FC236}">
                <a16:creationId xmlns:a16="http://schemas.microsoft.com/office/drawing/2014/main" id="{74FC6058-F904-D066-35D2-8FE7B6BBD4D3}"/>
              </a:ext>
            </a:extLst>
          </p:cNvPr>
          <p:cNvSpPr/>
          <p:nvPr/>
        </p:nvSpPr>
        <p:spPr>
          <a:xfrm>
            <a:off x="7926855" y="983737"/>
            <a:ext cx="3834418" cy="2836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     0.1              0.1                  1           (24hours)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9F648448-3D5C-06E9-0244-5B81771E4B83}"/>
              </a:ext>
            </a:extLst>
          </p:cNvPr>
          <p:cNvSpPr txBox="1"/>
          <p:nvPr/>
        </p:nvSpPr>
        <p:spPr>
          <a:xfrm>
            <a:off x="5962123" y="3157346"/>
            <a:ext cx="13840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21951502-2203-895F-7478-93C6B24D414D}"/>
              </a:ext>
            </a:extLst>
          </p:cNvPr>
          <p:cNvSpPr txBox="1"/>
          <p:nvPr/>
        </p:nvSpPr>
        <p:spPr>
          <a:xfrm>
            <a:off x="5998941" y="3780871"/>
            <a:ext cx="12077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818AC99C-7924-2474-E90A-A2AC717A75A0}"/>
              </a:ext>
            </a:extLst>
          </p:cNvPr>
          <p:cNvSpPr txBox="1"/>
          <p:nvPr/>
        </p:nvSpPr>
        <p:spPr>
          <a:xfrm>
            <a:off x="6032325" y="4130478"/>
            <a:ext cx="11409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26A178FD-6C08-A0DC-8F33-BB945D5FC590}"/>
              </a:ext>
            </a:extLst>
          </p:cNvPr>
          <p:cNvSpPr txBox="1"/>
          <p:nvPr/>
        </p:nvSpPr>
        <p:spPr>
          <a:xfrm>
            <a:off x="9426144" y="4714558"/>
            <a:ext cx="723275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TF</a:t>
            </a:r>
            <a:endParaRPr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Rectangle 68">
            <a:extLst>
              <a:ext uri="{FF2B5EF4-FFF2-40B4-BE49-F238E27FC236}">
                <a16:creationId xmlns:a16="http://schemas.microsoft.com/office/drawing/2014/main" id="{DD003159-9C1B-4DF4-AA8D-F626ADA1C972}"/>
              </a:ext>
            </a:extLst>
          </p:cNvPr>
          <p:cNvSpPr/>
          <p:nvPr/>
        </p:nvSpPr>
        <p:spPr>
          <a:xfrm>
            <a:off x="7983541" y="3317834"/>
            <a:ext cx="2510393" cy="1258190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4F75FD3E-85A3-BB01-0279-A383983A489B}"/>
              </a:ext>
            </a:extLst>
          </p:cNvPr>
          <p:cNvSpPr txBox="1"/>
          <p:nvPr/>
        </p:nvSpPr>
        <p:spPr>
          <a:xfrm>
            <a:off x="5985525" y="4537055"/>
            <a:ext cx="11409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E350EFA8-FC94-A3B8-A09B-EE733593BF48}"/>
              </a:ext>
            </a:extLst>
          </p:cNvPr>
          <p:cNvSpPr txBox="1"/>
          <p:nvPr/>
        </p:nvSpPr>
        <p:spPr>
          <a:xfrm>
            <a:off x="5985525" y="2883037"/>
            <a:ext cx="13840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C742984D-6618-2B42-0D99-7533450B436D}"/>
              </a:ext>
            </a:extLst>
          </p:cNvPr>
          <p:cNvSpPr txBox="1"/>
          <p:nvPr/>
        </p:nvSpPr>
        <p:spPr>
          <a:xfrm>
            <a:off x="5985526" y="2632663"/>
            <a:ext cx="13840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3" name="Table 37">
            <a:extLst>
              <a:ext uri="{FF2B5EF4-FFF2-40B4-BE49-F238E27FC236}">
                <a16:creationId xmlns:a16="http://schemas.microsoft.com/office/drawing/2014/main" id="{4375D0E6-1950-32EC-1C28-AB46CB8F73A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2353046"/>
              </p:ext>
            </p:extLst>
          </p:nvPr>
        </p:nvGraphicFramePr>
        <p:xfrm>
          <a:off x="7983541" y="1464284"/>
          <a:ext cx="797238" cy="10058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29132">
                  <a:extLst>
                    <a:ext uri="{9D8B030D-6E8A-4147-A177-3AD203B41FA5}">
                      <a16:colId xmlns:a16="http://schemas.microsoft.com/office/drawing/2014/main" val="2196274505"/>
                    </a:ext>
                  </a:extLst>
                </a:gridCol>
                <a:gridCol w="284053">
                  <a:extLst>
                    <a:ext uri="{9D8B030D-6E8A-4147-A177-3AD203B41FA5}">
                      <a16:colId xmlns:a16="http://schemas.microsoft.com/office/drawing/2014/main" val="2410484320"/>
                    </a:ext>
                  </a:extLst>
                </a:gridCol>
                <a:gridCol w="284053">
                  <a:extLst>
                    <a:ext uri="{9D8B030D-6E8A-4147-A177-3AD203B41FA5}">
                      <a16:colId xmlns:a16="http://schemas.microsoft.com/office/drawing/2014/main" val="2310628921"/>
                    </a:ext>
                  </a:extLst>
                </a:gridCol>
              </a:tblGrid>
              <a:tr h="17722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11382016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5747769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37971763"/>
                  </a:ext>
                </a:extLst>
              </a:tr>
            </a:tbl>
          </a:graphicData>
        </a:graphic>
      </p:graphicFrame>
      <p:graphicFrame>
        <p:nvGraphicFramePr>
          <p:cNvPr id="74" name="Table 37">
            <a:extLst>
              <a:ext uri="{FF2B5EF4-FFF2-40B4-BE49-F238E27FC236}">
                <a16:creationId xmlns:a16="http://schemas.microsoft.com/office/drawing/2014/main" id="{5B5CD766-0B9F-823F-49A3-0F8A8155C9E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9917863"/>
              </p:ext>
            </p:extLst>
          </p:nvPr>
        </p:nvGraphicFramePr>
        <p:xfrm>
          <a:off x="8817621" y="1454817"/>
          <a:ext cx="797238" cy="10058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29132">
                  <a:extLst>
                    <a:ext uri="{9D8B030D-6E8A-4147-A177-3AD203B41FA5}">
                      <a16:colId xmlns:a16="http://schemas.microsoft.com/office/drawing/2014/main" val="2196274505"/>
                    </a:ext>
                  </a:extLst>
                </a:gridCol>
                <a:gridCol w="284053">
                  <a:extLst>
                    <a:ext uri="{9D8B030D-6E8A-4147-A177-3AD203B41FA5}">
                      <a16:colId xmlns:a16="http://schemas.microsoft.com/office/drawing/2014/main" val="2410484320"/>
                    </a:ext>
                  </a:extLst>
                </a:gridCol>
                <a:gridCol w="284053">
                  <a:extLst>
                    <a:ext uri="{9D8B030D-6E8A-4147-A177-3AD203B41FA5}">
                      <a16:colId xmlns:a16="http://schemas.microsoft.com/office/drawing/2014/main" val="2310628921"/>
                    </a:ext>
                  </a:extLst>
                </a:gridCol>
              </a:tblGrid>
              <a:tr h="17722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11382016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5747769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37971763"/>
                  </a:ext>
                </a:extLst>
              </a:tr>
            </a:tbl>
          </a:graphicData>
        </a:graphic>
      </p:graphicFrame>
      <p:graphicFrame>
        <p:nvGraphicFramePr>
          <p:cNvPr id="75" name="Table 37">
            <a:extLst>
              <a:ext uri="{FF2B5EF4-FFF2-40B4-BE49-F238E27FC236}">
                <a16:creationId xmlns:a16="http://schemas.microsoft.com/office/drawing/2014/main" id="{5EF711D1-D399-99F0-FE97-29FE56D712A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11494274"/>
              </p:ext>
            </p:extLst>
          </p:nvPr>
        </p:nvGraphicFramePr>
        <p:xfrm>
          <a:off x="9619295" y="1444565"/>
          <a:ext cx="797238" cy="10058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29132">
                  <a:extLst>
                    <a:ext uri="{9D8B030D-6E8A-4147-A177-3AD203B41FA5}">
                      <a16:colId xmlns:a16="http://schemas.microsoft.com/office/drawing/2014/main" val="2196274505"/>
                    </a:ext>
                  </a:extLst>
                </a:gridCol>
                <a:gridCol w="284053">
                  <a:extLst>
                    <a:ext uri="{9D8B030D-6E8A-4147-A177-3AD203B41FA5}">
                      <a16:colId xmlns:a16="http://schemas.microsoft.com/office/drawing/2014/main" val="2410484320"/>
                    </a:ext>
                  </a:extLst>
                </a:gridCol>
                <a:gridCol w="284053">
                  <a:extLst>
                    <a:ext uri="{9D8B030D-6E8A-4147-A177-3AD203B41FA5}">
                      <a16:colId xmlns:a16="http://schemas.microsoft.com/office/drawing/2014/main" val="2310628921"/>
                    </a:ext>
                  </a:extLst>
                </a:gridCol>
              </a:tblGrid>
              <a:tr h="17722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11382016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5747769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37971763"/>
                  </a:ext>
                </a:extLst>
              </a:tr>
            </a:tbl>
          </a:graphicData>
        </a:graphic>
      </p:graphicFrame>
      <p:sp>
        <p:nvSpPr>
          <p:cNvPr id="76" name="TextBox 75">
            <a:extLst>
              <a:ext uri="{FF2B5EF4-FFF2-40B4-BE49-F238E27FC236}">
                <a16:creationId xmlns:a16="http://schemas.microsoft.com/office/drawing/2014/main" id="{DBD3B5D7-061A-BE7D-56BD-2BDA2E386E8A}"/>
              </a:ext>
            </a:extLst>
          </p:cNvPr>
          <p:cNvSpPr txBox="1"/>
          <p:nvPr/>
        </p:nvSpPr>
        <p:spPr>
          <a:xfrm>
            <a:off x="238858" y="189190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/>
              <a:t>Rep 1</a:t>
            </a:r>
            <a:endParaRPr dirty="0"/>
          </a:p>
        </p:txBody>
      </p:sp>
      <p:graphicFrame>
        <p:nvGraphicFramePr>
          <p:cNvPr id="77" name="Table 37">
            <a:extLst>
              <a:ext uri="{FF2B5EF4-FFF2-40B4-BE49-F238E27FC236}">
                <a16:creationId xmlns:a16="http://schemas.microsoft.com/office/drawing/2014/main" id="{26A1FEDC-AFAE-D691-9756-1014A97D3A8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34112236"/>
              </p:ext>
            </p:extLst>
          </p:nvPr>
        </p:nvGraphicFramePr>
        <p:xfrm>
          <a:off x="1505594" y="1372789"/>
          <a:ext cx="797238" cy="10058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29132">
                  <a:extLst>
                    <a:ext uri="{9D8B030D-6E8A-4147-A177-3AD203B41FA5}">
                      <a16:colId xmlns:a16="http://schemas.microsoft.com/office/drawing/2014/main" val="2196274505"/>
                    </a:ext>
                  </a:extLst>
                </a:gridCol>
                <a:gridCol w="284053">
                  <a:extLst>
                    <a:ext uri="{9D8B030D-6E8A-4147-A177-3AD203B41FA5}">
                      <a16:colId xmlns:a16="http://schemas.microsoft.com/office/drawing/2014/main" val="2410484320"/>
                    </a:ext>
                  </a:extLst>
                </a:gridCol>
                <a:gridCol w="284053">
                  <a:extLst>
                    <a:ext uri="{9D8B030D-6E8A-4147-A177-3AD203B41FA5}">
                      <a16:colId xmlns:a16="http://schemas.microsoft.com/office/drawing/2014/main" val="2310628921"/>
                    </a:ext>
                  </a:extLst>
                </a:gridCol>
              </a:tblGrid>
              <a:tr h="17722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11382016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5747769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37971763"/>
                  </a:ext>
                </a:extLst>
              </a:tr>
            </a:tbl>
          </a:graphicData>
        </a:graphic>
      </p:graphicFrame>
      <p:graphicFrame>
        <p:nvGraphicFramePr>
          <p:cNvPr id="78" name="Table 37">
            <a:extLst>
              <a:ext uri="{FF2B5EF4-FFF2-40B4-BE49-F238E27FC236}">
                <a16:creationId xmlns:a16="http://schemas.microsoft.com/office/drawing/2014/main" id="{BBEBA466-6861-7919-C4F3-5D3DE8E859C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02609054"/>
              </p:ext>
            </p:extLst>
          </p:nvPr>
        </p:nvGraphicFramePr>
        <p:xfrm>
          <a:off x="7230839" y="1475380"/>
          <a:ext cx="797238" cy="10058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29132">
                  <a:extLst>
                    <a:ext uri="{9D8B030D-6E8A-4147-A177-3AD203B41FA5}">
                      <a16:colId xmlns:a16="http://schemas.microsoft.com/office/drawing/2014/main" val="2196274505"/>
                    </a:ext>
                  </a:extLst>
                </a:gridCol>
                <a:gridCol w="284053">
                  <a:extLst>
                    <a:ext uri="{9D8B030D-6E8A-4147-A177-3AD203B41FA5}">
                      <a16:colId xmlns:a16="http://schemas.microsoft.com/office/drawing/2014/main" val="2410484320"/>
                    </a:ext>
                  </a:extLst>
                </a:gridCol>
                <a:gridCol w="284053">
                  <a:extLst>
                    <a:ext uri="{9D8B030D-6E8A-4147-A177-3AD203B41FA5}">
                      <a16:colId xmlns:a16="http://schemas.microsoft.com/office/drawing/2014/main" val="2310628921"/>
                    </a:ext>
                  </a:extLst>
                </a:gridCol>
              </a:tblGrid>
              <a:tr h="17722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11382016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5747769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3797176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6029659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7B7226D7-F816-4CB5-0D76-0BD846FD6FFD}"/>
              </a:ext>
            </a:extLst>
          </p:cNvPr>
          <p:cNvSpPr txBox="1"/>
          <p:nvPr/>
        </p:nvSpPr>
        <p:spPr>
          <a:xfrm>
            <a:off x="238858" y="189190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/>
              <a:t>Rep 2</a:t>
            </a:r>
            <a:endParaRPr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0B0BACE5-2400-83E6-92A2-F4440BFCB85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60618" y="2272682"/>
            <a:ext cx="4205600" cy="2282789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5B85BA0E-4000-1CEF-4482-493C04413DD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083202" y="2260838"/>
            <a:ext cx="4297391" cy="2332613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E2481577-0D54-FADA-3567-8D7E91FDB168}"/>
              </a:ext>
            </a:extLst>
          </p:cNvPr>
          <p:cNvSpPr txBox="1"/>
          <p:nvPr/>
        </p:nvSpPr>
        <p:spPr>
          <a:xfrm>
            <a:off x="1301294" y="1369369"/>
            <a:ext cx="20313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CHX 50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g/ml		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DA1D511-B7AE-9A01-1F00-E099C315E350}"/>
              </a:ext>
            </a:extLst>
          </p:cNvPr>
          <p:cNvSpPr txBox="1"/>
          <p:nvPr/>
        </p:nvSpPr>
        <p:spPr>
          <a:xfrm>
            <a:off x="1035507" y="1700074"/>
            <a:ext cx="29546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MG132 20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g/ml		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2EDC990-88BC-C652-46E7-D97A3E28ED0C}"/>
              </a:ext>
            </a:extLst>
          </p:cNvPr>
          <p:cNvSpPr txBox="1"/>
          <p:nvPr/>
        </p:nvSpPr>
        <p:spPr>
          <a:xfrm>
            <a:off x="988615" y="2025527"/>
            <a:ext cx="29546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Baf-A1 0.2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g/ml		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E6C9DF8D-2057-571A-6C83-38B8ADAA352E}"/>
              </a:ext>
            </a:extLst>
          </p:cNvPr>
          <p:cNvCxnSpPr>
            <a:cxnSpLocks/>
          </p:cNvCxnSpPr>
          <p:nvPr/>
        </p:nvCxnSpPr>
        <p:spPr>
          <a:xfrm>
            <a:off x="1860618" y="1273827"/>
            <a:ext cx="387716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Rectangle 10">
            <a:extLst>
              <a:ext uri="{FF2B5EF4-FFF2-40B4-BE49-F238E27FC236}">
                <a16:creationId xmlns:a16="http://schemas.microsoft.com/office/drawing/2014/main" id="{15F09021-9004-15E9-E847-B124C55B224A}"/>
              </a:ext>
            </a:extLst>
          </p:cNvPr>
          <p:cNvSpPr/>
          <p:nvPr/>
        </p:nvSpPr>
        <p:spPr>
          <a:xfrm>
            <a:off x="4072052" y="911422"/>
            <a:ext cx="76723" cy="88229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7D9CF14F-8F4B-F8EF-13DB-4D60BC3F6F0A}"/>
              </a:ext>
            </a:extLst>
          </p:cNvPr>
          <p:cNvSpPr/>
          <p:nvPr/>
        </p:nvSpPr>
        <p:spPr>
          <a:xfrm>
            <a:off x="5373772" y="924455"/>
            <a:ext cx="76723" cy="88229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892C09C-406F-85A1-E0AA-6878B6F150BB}"/>
              </a:ext>
            </a:extLst>
          </p:cNvPr>
          <p:cNvSpPr txBox="1"/>
          <p:nvPr/>
        </p:nvSpPr>
        <p:spPr>
          <a:xfrm>
            <a:off x="5398234" y="1680738"/>
            <a:ext cx="6527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3hours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4FAD2E9-7FFE-6AA3-FE84-6352146AAF94}"/>
              </a:ext>
            </a:extLst>
          </p:cNvPr>
          <p:cNvSpPr txBox="1"/>
          <p:nvPr/>
        </p:nvSpPr>
        <p:spPr>
          <a:xfrm>
            <a:off x="5398234" y="2040791"/>
            <a:ext cx="6527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3hours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4BC1EBD-4456-6FCE-CD83-62D1486F82DF}"/>
              </a:ext>
            </a:extLst>
          </p:cNvPr>
          <p:cNvSpPr txBox="1"/>
          <p:nvPr/>
        </p:nvSpPr>
        <p:spPr>
          <a:xfrm>
            <a:off x="5402673" y="1343713"/>
            <a:ext cx="6527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3hours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D28378EA-D007-3B60-B800-589508A1BDF1}"/>
              </a:ext>
            </a:extLst>
          </p:cNvPr>
          <p:cNvSpPr/>
          <p:nvPr/>
        </p:nvSpPr>
        <p:spPr>
          <a:xfrm>
            <a:off x="1455474" y="887968"/>
            <a:ext cx="179288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Dox (µg/ml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E27971F-1521-4A54-3944-0BD9683A0F12}"/>
              </a:ext>
            </a:extLst>
          </p:cNvPr>
          <p:cNvSpPr txBox="1"/>
          <p:nvPr/>
        </p:nvSpPr>
        <p:spPr>
          <a:xfrm>
            <a:off x="1448697" y="562515"/>
            <a:ext cx="104952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MITF</a:t>
            </a:r>
            <a:endParaRPr lang="en-GB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00FBEA3-B3DA-45C6-50F4-020D85CE34B2}"/>
              </a:ext>
            </a:extLst>
          </p:cNvPr>
          <p:cNvSpPr txBox="1"/>
          <p:nvPr/>
        </p:nvSpPr>
        <p:spPr>
          <a:xfrm>
            <a:off x="2520026" y="602677"/>
            <a:ext cx="383441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EV          WT             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                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058FE99C-0EB5-6F57-CC17-95D9E29E1FEF}"/>
              </a:ext>
            </a:extLst>
          </p:cNvPr>
          <p:cNvSpPr/>
          <p:nvPr/>
        </p:nvSpPr>
        <p:spPr>
          <a:xfrm>
            <a:off x="2925329" y="885054"/>
            <a:ext cx="3834418" cy="2836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     0.1              0.1                  1           (24hours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D0C0E7B-5D0C-D54C-2C34-C4E904840DD1}"/>
              </a:ext>
            </a:extLst>
          </p:cNvPr>
          <p:cNvSpPr txBox="1"/>
          <p:nvPr/>
        </p:nvSpPr>
        <p:spPr>
          <a:xfrm>
            <a:off x="1181478" y="2723518"/>
            <a:ext cx="13840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AF6C6BF-0511-CE3F-D5B0-556EB0891687}"/>
              </a:ext>
            </a:extLst>
          </p:cNvPr>
          <p:cNvSpPr txBox="1"/>
          <p:nvPr/>
        </p:nvSpPr>
        <p:spPr>
          <a:xfrm>
            <a:off x="1286808" y="3182493"/>
            <a:ext cx="12077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3E4C89C-0CAA-3BF1-BFB5-82BEFD754141}"/>
              </a:ext>
            </a:extLst>
          </p:cNvPr>
          <p:cNvSpPr txBox="1"/>
          <p:nvPr/>
        </p:nvSpPr>
        <p:spPr>
          <a:xfrm>
            <a:off x="1320192" y="3532100"/>
            <a:ext cx="11409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713E2272-2295-075E-4534-609C480BF5F6}"/>
              </a:ext>
            </a:extLst>
          </p:cNvPr>
          <p:cNvSpPr txBox="1"/>
          <p:nvPr/>
        </p:nvSpPr>
        <p:spPr>
          <a:xfrm>
            <a:off x="4605239" y="4057092"/>
            <a:ext cx="697627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5E8EB8ED-D3E4-15BF-9D50-32A6844DF9F0}"/>
              </a:ext>
            </a:extLst>
          </p:cNvPr>
          <p:cNvSpPr/>
          <p:nvPr/>
        </p:nvSpPr>
        <p:spPr>
          <a:xfrm>
            <a:off x="3068346" y="3406481"/>
            <a:ext cx="2424062" cy="431965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A3C36B14-9123-EA3A-6223-5447089583E2}"/>
              </a:ext>
            </a:extLst>
          </p:cNvPr>
          <p:cNvSpPr txBox="1"/>
          <p:nvPr/>
        </p:nvSpPr>
        <p:spPr>
          <a:xfrm>
            <a:off x="1273392" y="3852178"/>
            <a:ext cx="11409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6C95D55B-AB30-889E-9248-C1BB685367E2}"/>
              </a:ext>
            </a:extLst>
          </p:cNvPr>
          <p:cNvSpPr txBox="1"/>
          <p:nvPr/>
        </p:nvSpPr>
        <p:spPr>
          <a:xfrm>
            <a:off x="1204880" y="2449209"/>
            <a:ext cx="13840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9A4BF81E-3FDB-D608-34EB-AF0B4FCE4E25}"/>
              </a:ext>
            </a:extLst>
          </p:cNvPr>
          <p:cNvSpPr txBox="1"/>
          <p:nvPr/>
        </p:nvSpPr>
        <p:spPr>
          <a:xfrm>
            <a:off x="1204881" y="2198835"/>
            <a:ext cx="13840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9" name="Table 37">
            <a:extLst>
              <a:ext uri="{FF2B5EF4-FFF2-40B4-BE49-F238E27FC236}">
                <a16:creationId xmlns:a16="http://schemas.microsoft.com/office/drawing/2014/main" id="{0380476B-8004-8A97-9C2A-D04C0C3C13B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55127639"/>
              </p:ext>
            </p:extLst>
          </p:nvPr>
        </p:nvGraphicFramePr>
        <p:xfrm>
          <a:off x="2982015" y="1365601"/>
          <a:ext cx="797238" cy="10058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29132">
                  <a:extLst>
                    <a:ext uri="{9D8B030D-6E8A-4147-A177-3AD203B41FA5}">
                      <a16:colId xmlns:a16="http://schemas.microsoft.com/office/drawing/2014/main" val="2196274505"/>
                    </a:ext>
                  </a:extLst>
                </a:gridCol>
                <a:gridCol w="284053">
                  <a:extLst>
                    <a:ext uri="{9D8B030D-6E8A-4147-A177-3AD203B41FA5}">
                      <a16:colId xmlns:a16="http://schemas.microsoft.com/office/drawing/2014/main" val="2410484320"/>
                    </a:ext>
                  </a:extLst>
                </a:gridCol>
                <a:gridCol w="284053">
                  <a:extLst>
                    <a:ext uri="{9D8B030D-6E8A-4147-A177-3AD203B41FA5}">
                      <a16:colId xmlns:a16="http://schemas.microsoft.com/office/drawing/2014/main" val="2310628921"/>
                    </a:ext>
                  </a:extLst>
                </a:gridCol>
              </a:tblGrid>
              <a:tr h="17722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11382016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5747769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37971763"/>
                  </a:ext>
                </a:extLst>
              </a:tr>
            </a:tbl>
          </a:graphicData>
        </a:graphic>
      </p:graphicFrame>
      <p:graphicFrame>
        <p:nvGraphicFramePr>
          <p:cNvPr id="30" name="Table 37">
            <a:extLst>
              <a:ext uri="{FF2B5EF4-FFF2-40B4-BE49-F238E27FC236}">
                <a16:creationId xmlns:a16="http://schemas.microsoft.com/office/drawing/2014/main" id="{428FF425-DE99-7634-950F-511A1ECC639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44150774"/>
              </p:ext>
            </p:extLst>
          </p:nvPr>
        </p:nvGraphicFramePr>
        <p:xfrm>
          <a:off x="3816095" y="1356134"/>
          <a:ext cx="797238" cy="10058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29132">
                  <a:extLst>
                    <a:ext uri="{9D8B030D-6E8A-4147-A177-3AD203B41FA5}">
                      <a16:colId xmlns:a16="http://schemas.microsoft.com/office/drawing/2014/main" val="2196274505"/>
                    </a:ext>
                  </a:extLst>
                </a:gridCol>
                <a:gridCol w="284053">
                  <a:extLst>
                    <a:ext uri="{9D8B030D-6E8A-4147-A177-3AD203B41FA5}">
                      <a16:colId xmlns:a16="http://schemas.microsoft.com/office/drawing/2014/main" val="2410484320"/>
                    </a:ext>
                  </a:extLst>
                </a:gridCol>
                <a:gridCol w="284053">
                  <a:extLst>
                    <a:ext uri="{9D8B030D-6E8A-4147-A177-3AD203B41FA5}">
                      <a16:colId xmlns:a16="http://schemas.microsoft.com/office/drawing/2014/main" val="2310628921"/>
                    </a:ext>
                  </a:extLst>
                </a:gridCol>
              </a:tblGrid>
              <a:tr h="17722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11382016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5747769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37971763"/>
                  </a:ext>
                </a:extLst>
              </a:tr>
            </a:tbl>
          </a:graphicData>
        </a:graphic>
      </p:graphicFrame>
      <p:graphicFrame>
        <p:nvGraphicFramePr>
          <p:cNvPr id="31" name="Table 37">
            <a:extLst>
              <a:ext uri="{FF2B5EF4-FFF2-40B4-BE49-F238E27FC236}">
                <a16:creationId xmlns:a16="http://schemas.microsoft.com/office/drawing/2014/main" id="{A555E06B-0F58-22E1-22AE-9BEC9E32993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08213682"/>
              </p:ext>
            </p:extLst>
          </p:nvPr>
        </p:nvGraphicFramePr>
        <p:xfrm>
          <a:off x="4617769" y="1345882"/>
          <a:ext cx="797238" cy="10058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29132">
                  <a:extLst>
                    <a:ext uri="{9D8B030D-6E8A-4147-A177-3AD203B41FA5}">
                      <a16:colId xmlns:a16="http://schemas.microsoft.com/office/drawing/2014/main" val="2196274505"/>
                    </a:ext>
                  </a:extLst>
                </a:gridCol>
                <a:gridCol w="284053">
                  <a:extLst>
                    <a:ext uri="{9D8B030D-6E8A-4147-A177-3AD203B41FA5}">
                      <a16:colId xmlns:a16="http://schemas.microsoft.com/office/drawing/2014/main" val="2410484320"/>
                    </a:ext>
                  </a:extLst>
                </a:gridCol>
                <a:gridCol w="284053">
                  <a:extLst>
                    <a:ext uri="{9D8B030D-6E8A-4147-A177-3AD203B41FA5}">
                      <a16:colId xmlns:a16="http://schemas.microsoft.com/office/drawing/2014/main" val="2310628921"/>
                    </a:ext>
                  </a:extLst>
                </a:gridCol>
              </a:tblGrid>
              <a:tr h="17722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11382016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5747769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37971763"/>
                  </a:ext>
                </a:extLst>
              </a:tr>
            </a:tbl>
          </a:graphicData>
        </a:graphic>
      </p:graphicFrame>
      <p:graphicFrame>
        <p:nvGraphicFramePr>
          <p:cNvPr id="33" name="Table 37">
            <a:extLst>
              <a:ext uri="{FF2B5EF4-FFF2-40B4-BE49-F238E27FC236}">
                <a16:creationId xmlns:a16="http://schemas.microsoft.com/office/drawing/2014/main" id="{201FD360-B96D-6D0C-E10F-66B021A3DDB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85018352"/>
              </p:ext>
            </p:extLst>
          </p:nvPr>
        </p:nvGraphicFramePr>
        <p:xfrm>
          <a:off x="2255994" y="1334646"/>
          <a:ext cx="797238" cy="10058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29132">
                  <a:extLst>
                    <a:ext uri="{9D8B030D-6E8A-4147-A177-3AD203B41FA5}">
                      <a16:colId xmlns:a16="http://schemas.microsoft.com/office/drawing/2014/main" val="2196274505"/>
                    </a:ext>
                  </a:extLst>
                </a:gridCol>
                <a:gridCol w="284053">
                  <a:extLst>
                    <a:ext uri="{9D8B030D-6E8A-4147-A177-3AD203B41FA5}">
                      <a16:colId xmlns:a16="http://schemas.microsoft.com/office/drawing/2014/main" val="2410484320"/>
                    </a:ext>
                  </a:extLst>
                </a:gridCol>
                <a:gridCol w="284053">
                  <a:extLst>
                    <a:ext uri="{9D8B030D-6E8A-4147-A177-3AD203B41FA5}">
                      <a16:colId xmlns:a16="http://schemas.microsoft.com/office/drawing/2014/main" val="2310628921"/>
                    </a:ext>
                  </a:extLst>
                </a:gridCol>
              </a:tblGrid>
              <a:tr h="17722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11382016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5747769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37971763"/>
                  </a:ext>
                </a:extLst>
              </a:tr>
            </a:tbl>
          </a:graphicData>
        </a:graphic>
      </p:graphicFrame>
      <p:sp>
        <p:nvSpPr>
          <p:cNvPr id="35" name="TextBox 34">
            <a:extLst>
              <a:ext uri="{FF2B5EF4-FFF2-40B4-BE49-F238E27FC236}">
                <a16:creationId xmlns:a16="http://schemas.microsoft.com/office/drawing/2014/main" id="{F4DC367F-E523-DDCE-EC33-60F30F09F7F3}"/>
              </a:ext>
            </a:extLst>
          </p:cNvPr>
          <p:cNvSpPr txBox="1"/>
          <p:nvPr/>
        </p:nvSpPr>
        <p:spPr>
          <a:xfrm>
            <a:off x="6662107" y="1369369"/>
            <a:ext cx="20313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CHX 50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g/ml		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2B6F84A7-F7D2-AF21-D7EC-11D533446FBE}"/>
              </a:ext>
            </a:extLst>
          </p:cNvPr>
          <p:cNvSpPr txBox="1"/>
          <p:nvPr/>
        </p:nvSpPr>
        <p:spPr>
          <a:xfrm>
            <a:off x="6396320" y="1700074"/>
            <a:ext cx="29546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MG132 20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g/ml		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A5F1CD9B-7CE6-5FD4-4879-BBFE30A41E89}"/>
              </a:ext>
            </a:extLst>
          </p:cNvPr>
          <p:cNvSpPr txBox="1"/>
          <p:nvPr/>
        </p:nvSpPr>
        <p:spPr>
          <a:xfrm>
            <a:off x="6349428" y="2025527"/>
            <a:ext cx="29546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Baf-A1 0.2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g/ml		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6C41243C-238B-384E-DE08-EA266E7C348F}"/>
              </a:ext>
            </a:extLst>
          </p:cNvPr>
          <p:cNvCxnSpPr>
            <a:cxnSpLocks/>
          </p:cNvCxnSpPr>
          <p:nvPr/>
        </p:nvCxnSpPr>
        <p:spPr>
          <a:xfrm>
            <a:off x="7221431" y="1273827"/>
            <a:ext cx="387716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Rectangle 38">
            <a:extLst>
              <a:ext uri="{FF2B5EF4-FFF2-40B4-BE49-F238E27FC236}">
                <a16:creationId xmlns:a16="http://schemas.microsoft.com/office/drawing/2014/main" id="{D7A00BA5-A2EB-D5FE-AA47-60F207FBE8FC}"/>
              </a:ext>
            </a:extLst>
          </p:cNvPr>
          <p:cNvSpPr/>
          <p:nvPr/>
        </p:nvSpPr>
        <p:spPr>
          <a:xfrm>
            <a:off x="9432865" y="911422"/>
            <a:ext cx="76723" cy="88229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D0DED7EC-032B-DC81-2C7D-33956FDCF42E}"/>
              </a:ext>
            </a:extLst>
          </p:cNvPr>
          <p:cNvSpPr/>
          <p:nvPr/>
        </p:nvSpPr>
        <p:spPr>
          <a:xfrm>
            <a:off x="10734585" y="924455"/>
            <a:ext cx="76723" cy="88229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C5414687-733F-B5E0-0047-A4DCFAD8894A}"/>
              </a:ext>
            </a:extLst>
          </p:cNvPr>
          <p:cNvSpPr txBox="1"/>
          <p:nvPr/>
        </p:nvSpPr>
        <p:spPr>
          <a:xfrm>
            <a:off x="10759047" y="1680738"/>
            <a:ext cx="6527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3hours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40518874-F89A-97A3-3434-C28711FCAA1D}"/>
              </a:ext>
            </a:extLst>
          </p:cNvPr>
          <p:cNvSpPr txBox="1"/>
          <p:nvPr/>
        </p:nvSpPr>
        <p:spPr>
          <a:xfrm>
            <a:off x="10759047" y="2040791"/>
            <a:ext cx="6527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3hours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9A733872-6643-67A9-F0A3-D21C4B1EF143}"/>
              </a:ext>
            </a:extLst>
          </p:cNvPr>
          <p:cNvSpPr txBox="1"/>
          <p:nvPr/>
        </p:nvSpPr>
        <p:spPr>
          <a:xfrm>
            <a:off x="10763486" y="1343713"/>
            <a:ext cx="6527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3hours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17D6C2AB-A2B8-7FB2-3C1B-84B896B9F16F}"/>
              </a:ext>
            </a:extLst>
          </p:cNvPr>
          <p:cNvSpPr/>
          <p:nvPr/>
        </p:nvSpPr>
        <p:spPr>
          <a:xfrm>
            <a:off x="6816287" y="887968"/>
            <a:ext cx="179288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Dox (µg/ml)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930A137C-F7C3-9E76-8AC9-BC33F2561A2C}"/>
              </a:ext>
            </a:extLst>
          </p:cNvPr>
          <p:cNvSpPr txBox="1"/>
          <p:nvPr/>
        </p:nvSpPr>
        <p:spPr>
          <a:xfrm>
            <a:off x="6809510" y="562515"/>
            <a:ext cx="104952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MITF</a:t>
            </a:r>
            <a:endParaRPr lang="en-GB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CBFDDBFA-5DF6-530A-CA01-5C05A441C37F}"/>
              </a:ext>
            </a:extLst>
          </p:cNvPr>
          <p:cNvSpPr txBox="1"/>
          <p:nvPr/>
        </p:nvSpPr>
        <p:spPr>
          <a:xfrm>
            <a:off x="7880839" y="602677"/>
            <a:ext cx="383441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EV          WT             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                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F73DBF95-9D77-1614-1321-8E1E682467DF}"/>
              </a:ext>
            </a:extLst>
          </p:cNvPr>
          <p:cNvSpPr/>
          <p:nvPr/>
        </p:nvSpPr>
        <p:spPr>
          <a:xfrm>
            <a:off x="8286142" y="885054"/>
            <a:ext cx="3834418" cy="2836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     0.1              0.1                  1           (24hours)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BC47BCEE-9080-769C-C83B-56AA224D146F}"/>
              </a:ext>
            </a:extLst>
          </p:cNvPr>
          <p:cNvSpPr txBox="1"/>
          <p:nvPr/>
        </p:nvSpPr>
        <p:spPr>
          <a:xfrm>
            <a:off x="6542291" y="2723518"/>
            <a:ext cx="13840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8CC8573B-8055-EA48-CAB0-1F401CEEDA18}"/>
              </a:ext>
            </a:extLst>
          </p:cNvPr>
          <p:cNvSpPr txBox="1"/>
          <p:nvPr/>
        </p:nvSpPr>
        <p:spPr>
          <a:xfrm>
            <a:off x="6647621" y="3182493"/>
            <a:ext cx="12077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3E80926B-6449-838A-E3D3-0BF2D01A1BE2}"/>
              </a:ext>
            </a:extLst>
          </p:cNvPr>
          <p:cNvSpPr txBox="1"/>
          <p:nvPr/>
        </p:nvSpPr>
        <p:spPr>
          <a:xfrm>
            <a:off x="6681005" y="3532100"/>
            <a:ext cx="11409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21F29748-4B6E-EB91-8C5C-B48C213D8F59}"/>
              </a:ext>
            </a:extLst>
          </p:cNvPr>
          <p:cNvSpPr txBox="1"/>
          <p:nvPr/>
        </p:nvSpPr>
        <p:spPr>
          <a:xfrm>
            <a:off x="9966052" y="4057092"/>
            <a:ext cx="723275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TF</a:t>
            </a:r>
            <a:endParaRPr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058FB6DA-1DCE-4AAC-5D17-4C5A1F9732AD}"/>
              </a:ext>
            </a:extLst>
          </p:cNvPr>
          <p:cNvSpPr/>
          <p:nvPr/>
        </p:nvSpPr>
        <p:spPr>
          <a:xfrm>
            <a:off x="8270961" y="2814640"/>
            <a:ext cx="2424062" cy="1037538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8B22DFC2-5B62-DFB6-4BEA-8DA899D38974}"/>
              </a:ext>
            </a:extLst>
          </p:cNvPr>
          <p:cNvSpPr txBox="1"/>
          <p:nvPr/>
        </p:nvSpPr>
        <p:spPr>
          <a:xfrm>
            <a:off x="6634205" y="3852178"/>
            <a:ext cx="11409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1675D777-5616-B453-C4E2-03775757FF54}"/>
              </a:ext>
            </a:extLst>
          </p:cNvPr>
          <p:cNvSpPr txBox="1"/>
          <p:nvPr/>
        </p:nvSpPr>
        <p:spPr>
          <a:xfrm>
            <a:off x="6565693" y="2449209"/>
            <a:ext cx="13840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ACAC1372-8C28-B839-B170-78470CE70333}"/>
              </a:ext>
            </a:extLst>
          </p:cNvPr>
          <p:cNvSpPr txBox="1"/>
          <p:nvPr/>
        </p:nvSpPr>
        <p:spPr>
          <a:xfrm>
            <a:off x="6565694" y="2198835"/>
            <a:ext cx="13840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6" name="Table 37">
            <a:extLst>
              <a:ext uri="{FF2B5EF4-FFF2-40B4-BE49-F238E27FC236}">
                <a16:creationId xmlns:a16="http://schemas.microsoft.com/office/drawing/2014/main" id="{6E75C088-AADA-E7D5-1DD2-1E480480102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30537344"/>
              </p:ext>
            </p:extLst>
          </p:nvPr>
        </p:nvGraphicFramePr>
        <p:xfrm>
          <a:off x="8342828" y="1365601"/>
          <a:ext cx="797238" cy="10058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29132">
                  <a:extLst>
                    <a:ext uri="{9D8B030D-6E8A-4147-A177-3AD203B41FA5}">
                      <a16:colId xmlns:a16="http://schemas.microsoft.com/office/drawing/2014/main" val="2196274505"/>
                    </a:ext>
                  </a:extLst>
                </a:gridCol>
                <a:gridCol w="284053">
                  <a:extLst>
                    <a:ext uri="{9D8B030D-6E8A-4147-A177-3AD203B41FA5}">
                      <a16:colId xmlns:a16="http://schemas.microsoft.com/office/drawing/2014/main" val="2410484320"/>
                    </a:ext>
                  </a:extLst>
                </a:gridCol>
                <a:gridCol w="284053">
                  <a:extLst>
                    <a:ext uri="{9D8B030D-6E8A-4147-A177-3AD203B41FA5}">
                      <a16:colId xmlns:a16="http://schemas.microsoft.com/office/drawing/2014/main" val="2310628921"/>
                    </a:ext>
                  </a:extLst>
                </a:gridCol>
              </a:tblGrid>
              <a:tr h="17722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11382016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5747769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37971763"/>
                  </a:ext>
                </a:extLst>
              </a:tr>
            </a:tbl>
          </a:graphicData>
        </a:graphic>
      </p:graphicFrame>
      <p:graphicFrame>
        <p:nvGraphicFramePr>
          <p:cNvPr id="57" name="Table 37">
            <a:extLst>
              <a:ext uri="{FF2B5EF4-FFF2-40B4-BE49-F238E27FC236}">
                <a16:creationId xmlns:a16="http://schemas.microsoft.com/office/drawing/2014/main" id="{00534DA9-262C-2765-616A-762A372467F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2564253"/>
              </p:ext>
            </p:extLst>
          </p:nvPr>
        </p:nvGraphicFramePr>
        <p:xfrm>
          <a:off x="9176908" y="1356134"/>
          <a:ext cx="797238" cy="10058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29132">
                  <a:extLst>
                    <a:ext uri="{9D8B030D-6E8A-4147-A177-3AD203B41FA5}">
                      <a16:colId xmlns:a16="http://schemas.microsoft.com/office/drawing/2014/main" val="2196274505"/>
                    </a:ext>
                  </a:extLst>
                </a:gridCol>
                <a:gridCol w="284053">
                  <a:extLst>
                    <a:ext uri="{9D8B030D-6E8A-4147-A177-3AD203B41FA5}">
                      <a16:colId xmlns:a16="http://schemas.microsoft.com/office/drawing/2014/main" val="2410484320"/>
                    </a:ext>
                  </a:extLst>
                </a:gridCol>
                <a:gridCol w="284053">
                  <a:extLst>
                    <a:ext uri="{9D8B030D-6E8A-4147-A177-3AD203B41FA5}">
                      <a16:colId xmlns:a16="http://schemas.microsoft.com/office/drawing/2014/main" val="2310628921"/>
                    </a:ext>
                  </a:extLst>
                </a:gridCol>
              </a:tblGrid>
              <a:tr h="17722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11382016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5747769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37971763"/>
                  </a:ext>
                </a:extLst>
              </a:tr>
            </a:tbl>
          </a:graphicData>
        </a:graphic>
      </p:graphicFrame>
      <p:graphicFrame>
        <p:nvGraphicFramePr>
          <p:cNvPr id="58" name="Table 37">
            <a:extLst>
              <a:ext uri="{FF2B5EF4-FFF2-40B4-BE49-F238E27FC236}">
                <a16:creationId xmlns:a16="http://schemas.microsoft.com/office/drawing/2014/main" id="{E51901AE-079C-A7BA-AD93-FDCBA6E0D33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2904379"/>
              </p:ext>
            </p:extLst>
          </p:nvPr>
        </p:nvGraphicFramePr>
        <p:xfrm>
          <a:off x="9978582" y="1345882"/>
          <a:ext cx="797238" cy="10058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29132">
                  <a:extLst>
                    <a:ext uri="{9D8B030D-6E8A-4147-A177-3AD203B41FA5}">
                      <a16:colId xmlns:a16="http://schemas.microsoft.com/office/drawing/2014/main" val="2196274505"/>
                    </a:ext>
                  </a:extLst>
                </a:gridCol>
                <a:gridCol w="284053">
                  <a:extLst>
                    <a:ext uri="{9D8B030D-6E8A-4147-A177-3AD203B41FA5}">
                      <a16:colId xmlns:a16="http://schemas.microsoft.com/office/drawing/2014/main" val="2410484320"/>
                    </a:ext>
                  </a:extLst>
                </a:gridCol>
                <a:gridCol w="284053">
                  <a:extLst>
                    <a:ext uri="{9D8B030D-6E8A-4147-A177-3AD203B41FA5}">
                      <a16:colId xmlns:a16="http://schemas.microsoft.com/office/drawing/2014/main" val="2310628921"/>
                    </a:ext>
                  </a:extLst>
                </a:gridCol>
              </a:tblGrid>
              <a:tr h="17722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11382016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5747769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37971763"/>
                  </a:ext>
                </a:extLst>
              </a:tr>
            </a:tbl>
          </a:graphicData>
        </a:graphic>
      </p:graphicFrame>
      <p:graphicFrame>
        <p:nvGraphicFramePr>
          <p:cNvPr id="60" name="Table 37">
            <a:extLst>
              <a:ext uri="{FF2B5EF4-FFF2-40B4-BE49-F238E27FC236}">
                <a16:creationId xmlns:a16="http://schemas.microsoft.com/office/drawing/2014/main" id="{CEB51C37-F323-5A0D-A994-F88CE7CB16B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3475240"/>
              </p:ext>
            </p:extLst>
          </p:nvPr>
        </p:nvGraphicFramePr>
        <p:xfrm>
          <a:off x="7616807" y="1334646"/>
          <a:ext cx="797238" cy="10058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29132">
                  <a:extLst>
                    <a:ext uri="{9D8B030D-6E8A-4147-A177-3AD203B41FA5}">
                      <a16:colId xmlns:a16="http://schemas.microsoft.com/office/drawing/2014/main" val="2196274505"/>
                    </a:ext>
                  </a:extLst>
                </a:gridCol>
                <a:gridCol w="284053">
                  <a:extLst>
                    <a:ext uri="{9D8B030D-6E8A-4147-A177-3AD203B41FA5}">
                      <a16:colId xmlns:a16="http://schemas.microsoft.com/office/drawing/2014/main" val="2410484320"/>
                    </a:ext>
                  </a:extLst>
                </a:gridCol>
                <a:gridCol w="284053">
                  <a:extLst>
                    <a:ext uri="{9D8B030D-6E8A-4147-A177-3AD203B41FA5}">
                      <a16:colId xmlns:a16="http://schemas.microsoft.com/office/drawing/2014/main" val="2310628921"/>
                    </a:ext>
                  </a:extLst>
                </a:gridCol>
              </a:tblGrid>
              <a:tr h="17722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11382016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5747769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3797176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4787193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A09F3FC0-1FF0-7E50-0E71-9E07248B5EE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60202" y="2318393"/>
            <a:ext cx="4136173" cy="258187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4FB17ECD-D731-4533-A3BC-B6AD8683EDC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61479" y="2317790"/>
            <a:ext cx="4136173" cy="258187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CE2C83B-4F11-0942-BAC6-5F27951A8089}"/>
              </a:ext>
            </a:extLst>
          </p:cNvPr>
          <p:cNvSpPr txBox="1"/>
          <p:nvPr/>
        </p:nvSpPr>
        <p:spPr>
          <a:xfrm>
            <a:off x="238858" y="189190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/>
              <a:t>Rep 3</a:t>
            </a:r>
            <a:endParaRPr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E205271-3E57-890F-C5C6-EE763D2B1CEB}"/>
              </a:ext>
            </a:extLst>
          </p:cNvPr>
          <p:cNvSpPr txBox="1"/>
          <p:nvPr/>
        </p:nvSpPr>
        <p:spPr>
          <a:xfrm>
            <a:off x="1301294" y="1369369"/>
            <a:ext cx="20313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CHX 50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g/ml		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4A91089-CC23-0F4E-DED8-FC76FABA42B6}"/>
              </a:ext>
            </a:extLst>
          </p:cNvPr>
          <p:cNvSpPr txBox="1"/>
          <p:nvPr/>
        </p:nvSpPr>
        <p:spPr>
          <a:xfrm>
            <a:off x="1035507" y="1700074"/>
            <a:ext cx="29546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MG132 20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g/ml		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55D4292-0180-140C-2B07-8953E721B2A1}"/>
              </a:ext>
            </a:extLst>
          </p:cNvPr>
          <p:cNvSpPr txBox="1"/>
          <p:nvPr/>
        </p:nvSpPr>
        <p:spPr>
          <a:xfrm>
            <a:off x="988615" y="2025527"/>
            <a:ext cx="29546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Baf-A1 0.2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g/ml		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0ED5634E-F59F-47B3-6F13-B3FD6A2CF7CF}"/>
              </a:ext>
            </a:extLst>
          </p:cNvPr>
          <p:cNvCxnSpPr>
            <a:cxnSpLocks/>
          </p:cNvCxnSpPr>
          <p:nvPr/>
        </p:nvCxnSpPr>
        <p:spPr>
          <a:xfrm>
            <a:off x="1860618" y="1273827"/>
            <a:ext cx="387716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Rectangle 11">
            <a:extLst>
              <a:ext uri="{FF2B5EF4-FFF2-40B4-BE49-F238E27FC236}">
                <a16:creationId xmlns:a16="http://schemas.microsoft.com/office/drawing/2014/main" id="{5E241201-6AA3-6DE6-F17A-713273FBC3AE}"/>
              </a:ext>
            </a:extLst>
          </p:cNvPr>
          <p:cNvSpPr/>
          <p:nvPr/>
        </p:nvSpPr>
        <p:spPr>
          <a:xfrm>
            <a:off x="4072052" y="911422"/>
            <a:ext cx="76723" cy="88229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9D8C86DF-E072-45B6-00DE-EC47827E474C}"/>
              </a:ext>
            </a:extLst>
          </p:cNvPr>
          <p:cNvSpPr/>
          <p:nvPr/>
        </p:nvSpPr>
        <p:spPr>
          <a:xfrm>
            <a:off x="5373772" y="924455"/>
            <a:ext cx="76723" cy="88229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F5A586F-F184-D80D-7FE4-26E29197B654}"/>
              </a:ext>
            </a:extLst>
          </p:cNvPr>
          <p:cNvSpPr txBox="1"/>
          <p:nvPr/>
        </p:nvSpPr>
        <p:spPr>
          <a:xfrm>
            <a:off x="5398234" y="1680738"/>
            <a:ext cx="6527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3hours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0F8CF19-228F-381A-21A2-575591BE2D3E}"/>
              </a:ext>
            </a:extLst>
          </p:cNvPr>
          <p:cNvSpPr txBox="1"/>
          <p:nvPr/>
        </p:nvSpPr>
        <p:spPr>
          <a:xfrm>
            <a:off x="5398234" y="2040791"/>
            <a:ext cx="6527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3hours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3A45FD2-B3F8-DE15-7781-CFB5A0419453}"/>
              </a:ext>
            </a:extLst>
          </p:cNvPr>
          <p:cNvSpPr txBox="1"/>
          <p:nvPr/>
        </p:nvSpPr>
        <p:spPr>
          <a:xfrm>
            <a:off x="5402673" y="1343713"/>
            <a:ext cx="6527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3hours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85489C45-608B-226E-7C52-4DF66A53EED5}"/>
              </a:ext>
            </a:extLst>
          </p:cNvPr>
          <p:cNvSpPr/>
          <p:nvPr/>
        </p:nvSpPr>
        <p:spPr>
          <a:xfrm>
            <a:off x="1455474" y="887968"/>
            <a:ext cx="179288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Dox (µg/ml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84ADCF2-A1DA-BA9A-4305-A4CFBD95D263}"/>
              </a:ext>
            </a:extLst>
          </p:cNvPr>
          <p:cNvSpPr txBox="1"/>
          <p:nvPr/>
        </p:nvSpPr>
        <p:spPr>
          <a:xfrm>
            <a:off x="1448697" y="562515"/>
            <a:ext cx="104952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MITF</a:t>
            </a:r>
            <a:endParaRPr lang="en-GB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BEFC563-0799-3343-2A7A-0FF717E698F4}"/>
              </a:ext>
            </a:extLst>
          </p:cNvPr>
          <p:cNvSpPr txBox="1"/>
          <p:nvPr/>
        </p:nvSpPr>
        <p:spPr>
          <a:xfrm>
            <a:off x="2520026" y="602677"/>
            <a:ext cx="383441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EV          WT             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                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87E5428C-2CDC-43F9-BF01-1C7B509B78F8}"/>
              </a:ext>
            </a:extLst>
          </p:cNvPr>
          <p:cNvSpPr/>
          <p:nvPr/>
        </p:nvSpPr>
        <p:spPr>
          <a:xfrm>
            <a:off x="2925329" y="885054"/>
            <a:ext cx="3834418" cy="2836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     0.1              0.1                  1           (24hours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141519E-8157-C08D-6E5D-E10070D2CC35}"/>
              </a:ext>
            </a:extLst>
          </p:cNvPr>
          <p:cNvSpPr txBox="1"/>
          <p:nvPr/>
        </p:nvSpPr>
        <p:spPr>
          <a:xfrm>
            <a:off x="1181478" y="2772946"/>
            <a:ext cx="13840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17823BB-0924-9596-67B9-5A68FA84EBE8}"/>
              </a:ext>
            </a:extLst>
          </p:cNvPr>
          <p:cNvSpPr txBox="1"/>
          <p:nvPr/>
        </p:nvSpPr>
        <p:spPr>
          <a:xfrm>
            <a:off x="1286808" y="3231921"/>
            <a:ext cx="12077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2F5EDC5D-E663-5A56-A63C-989DAF533CB9}"/>
              </a:ext>
            </a:extLst>
          </p:cNvPr>
          <p:cNvSpPr txBox="1"/>
          <p:nvPr/>
        </p:nvSpPr>
        <p:spPr>
          <a:xfrm>
            <a:off x="1320192" y="3581528"/>
            <a:ext cx="11409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BF783E04-14DD-109B-66C3-33F92CCA906D}"/>
              </a:ext>
            </a:extLst>
          </p:cNvPr>
          <p:cNvSpPr txBox="1"/>
          <p:nvPr/>
        </p:nvSpPr>
        <p:spPr>
          <a:xfrm>
            <a:off x="4605239" y="4057092"/>
            <a:ext cx="697627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81D915EE-A282-EF43-D61A-C410BB8AE70C}"/>
              </a:ext>
            </a:extLst>
          </p:cNvPr>
          <p:cNvSpPr/>
          <p:nvPr/>
        </p:nvSpPr>
        <p:spPr>
          <a:xfrm>
            <a:off x="3068346" y="3406481"/>
            <a:ext cx="2424062" cy="431965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F11F3040-00B9-476C-429A-37E25F5D10D3}"/>
              </a:ext>
            </a:extLst>
          </p:cNvPr>
          <p:cNvSpPr txBox="1"/>
          <p:nvPr/>
        </p:nvSpPr>
        <p:spPr>
          <a:xfrm>
            <a:off x="1273392" y="3901606"/>
            <a:ext cx="11409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7F424AC-E70A-2569-C242-BE0C8D110727}"/>
              </a:ext>
            </a:extLst>
          </p:cNvPr>
          <p:cNvSpPr txBox="1"/>
          <p:nvPr/>
        </p:nvSpPr>
        <p:spPr>
          <a:xfrm>
            <a:off x="1204880" y="2498637"/>
            <a:ext cx="13840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D4D33E8A-5190-E7FA-E1F1-78DCCAE7D157}"/>
              </a:ext>
            </a:extLst>
          </p:cNvPr>
          <p:cNvSpPr txBox="1"/>
          <p:nvPr/>
        </p:nvSpPr>
        <p:spPr>
          <a:xfrm>
            <a:off x="1204881" y="2248263"/>
            <a:ext cx="13840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9" name="Table 37">
            <a:extLst>
              <a:ext uri="{FF2B5EF4-FFF2-40B4-BE49-F238E27FC236}">
                <a16:creationId xmlns:a16="http://schemas.microsoft.com/office/drawing/2014/main" id="{E1F5AE80-FBEE-8BD7-193D-E7E5FD957D2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88546990"/>
              </p:ext>
            </p:extLst>
          </p:nvPr>
        </p:nvGraphicFramePr>
        <p:xfrm>
          <a:off x="2982015" y="1365601"/>
          <a:ext cx="797238" cy="10058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29132">
                  <a:extLst>
                    <a:ext uri="{9D8B030D-6E8A-4147-A177-3AD203B41FA5}">
                      <a16:colId xmlns:a16="http://schemas.microsoft.com/office/drawing/2014/main" val="2196274505"/>
                    </a:ext>
                  </a:extLst>
                </a:gridCol>
                <a:gridCol w="284053">
                  <a:extLst>
                    <a:ext uri="{9D8B030D-6E8A-4147-A177-3AD203B41FA5}">
                      <a16:colId xmlns:a16="http://schemas.microsoft.com/office/drawing/2014/main" val="2410484320"/>
                    </a:ext>
                  </a:extLst>
                </a:gridCol>
                <a:gridCol w="284053">
                  <a:extLst>
                    <a:ext uri="{9D8B030D-6E8A-4147-A177-3AD203B41FA5}">
                      <a16:colId xmlns:a16="http://schemas.microsoft.com/office/drawing/2014/main" val="2310628921"/>
                    </a:ext>
                  </a:extLst>
                </a:gridCol>
              </a:tblGrid>
              <a:tr h="17722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11382016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5747769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37971763"/>
                  </a:ext>
                </a:extLst>
              </a:tr>
            </a:tbl>
          </a:graphicData>
        </a:graphic>
      </p:graphicFrame>
      <p:graphicFrame>
        <p:nvGraphicFramePr>
          <p:cNvPr id="30" name="Table 37">
            <a:extLst>
              <a:ext uri="{FF2B5EF4-FFF2-40B4-BE49-F238E27FC236}">
                <a16:creationId xmlns:a16="http://schemas.microsoft.com/office/drawing/2014/main" id="{8BC37516-0750-8035-D094-7D19C76F763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69323529"/>
              </p:ext>
            </p:extLst>
          </p:nvPr>
        </p:nvGraphicFramePr>
        <p:xfrm>
          <a:off x="3816095" y="1356134"/>
          <a:ext cx="797238" cy="10058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29132">
                  <a:extLst>
                    <a:ext uri="{9D8B030D-6E8A-4147-A177-3AD203B41FA5}">
                      <a16:colId xmlns:a16="http://schemas.microsoft.com/office/drawing/2014/main" val="2196274505"/>
                    </a:ext>
                  </a:extLst>
                </a:gridCol>
                <a:gridCol w="284053">
                  <a:extLst>
                    <a:ext uri="{9D8B030D-6E8A-4147-A177-3AD203B41FA5}">
                      <a16:colId xmlns:a16="http://schemas.microsoft.com/office/drawing/2014/main" val="2410484320"/>
                    </a:ext>
                  </a:extLst>
                </a:gridCol>
                <a:gridCol w="284053">
                  <a:extLst>
                    <a:ext uri="{9D8B030D-6E8A-4147-A177-3AD203B41FA5}">
                      <a16:colId xmlns:a16="http://schemas.microsoft.com/office/drawing/2014/main" val="2310628921"/>
                    </a:ext>
                  </a:extLst>
                </a:gridCol>
              </a:tblGrid>
              <a:tr h="17722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11382016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5747769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37971763"/>
                  </a:ext>
                </a:extLst>
              </a:tr>
            </a:tbl>
          </a:graphicData>
        </a:graphic>
      </p:graphicFrame>
      <p:graphicFrame>
        <p:nvGraphicFramePr>
          <p:cNvPr id="31" name="Table 37">
            <a:extLst>
              <a:ext uri="{FF2B5EF4-FFF2-40B4-BE49-F238E27FC236}">
                <a16:creationId xmlns:a16="http://schemas.microsoft.com/office/drawing/2014/main" id="{083538FB-D2E9-E320-66EF-279DEAB7FEA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92906476"/>
              </p:ext>
            </p:extLst>
          </p:nvPr>
        </p:nvGraphicFramePr>
        <p:xfrm>
          <a:off x="4617769" y="1345882"/>
          <a:ext cx="797238" cy="10058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29132">
                  <a:extLst>
                    <a:ext uri="{9D8B030D-6E8A-4147-A177-3AD203B41FA5}">
                      <a16:colId xmlns:a16="http://schemas.microsoft.com/office/drawing/2014/main" val="2196274505"/>
                    </a:ext>
                  </a:extLst>
                </a:gridCol>
                <a:gridCol w="284053">
                  <a:extLst>
                    <a:ext uri="{9D8B030D-6E8A-4147-A177-3AD203B41FA5}">
                      <a16:colId xmlns:a16="http://schemas.microsoft.com/office/drawing/2014/main" val="2410484320"/>
                    </a:ext>
                  </a:extLst>
                </a:gridCol>
                <a:gridCol w="284053">
                  <a:extLst>
                    <a:ext uri="{9D8B030D-6E8A-4147-A177-3AD203B41FA5}">
                      <a16:colId xmlns:a16="http://schemas.microsoft.com/office/drawing/2014/main" val="2310628921"/>
                    </a:ext>
                  </a:extLst>
                </a:gridCol>
              </a:tblGrid>
              <a:tr h="17722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11382016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5747769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37971763"/>
                  </a:ext>
                </a:extLst>
              </a:tr>
            </a:tbl>
          </a:graphicData>
        </a:graphic>
      </p:graphicFrame>
      <p:graphicFrame>
        <p:nvGraphicFramePr>
          <p:cNvPr id="32" name="Table 37">
            <a:extLst>
              <a:ext uri="{FF2B5EF4-FFF2-40B4-BE49-F238E27FC236}">
                <a16:creationId xmlns:a16="http://schemas.microsoft.com/office/drawing/2014/main" id="{F49113B5-BED1-A176-F12F-D4F16196188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86424366"/>
              </p:ext>
            </p:extLst>
          </p:nvPr>
        </p:nvGraphicFramePr>
        <p:xfrm>
          <a:off x="2255994" y="1334646"/>
          <a:ext cx="797238" cy="10058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29132">
                  <a:extLst>
                    <a:ext uri="{9D8B030D-6E8A-4147-A177-3AD203B41FA5}">
                      <a16:colId xmlns:a16="http://schemas.microsoft.com/office/drawing/2014/main" val="2196274505"/>
                    </a:ext>
                  </a:extLst>
                </a:gridCol>
                <a:gridCol w="284053">
                  <a:extLst>
                    <a:ext uri="{9D8B030D-6E8A-4147-A177-3AD203B41FA5}">
                      <a16:colId xmlns:a16="http://schemas.microsoft.com/office/drawing/2014/main" val="2410484320"/>
                    </a:ext>
                  </a:extLst>
                </a:gridCol>
                <a:gridCol w="284053">
                  <a:extLst>
                    <a:ext uri="{9D8B030D-6E8A-4147-A177-3AD203B41FA5}">
                      <a16:colId xmlns:a16="http://schemas.microsoft.com/office/drawing/2014/main" val="2310628921"/>
                    </a:ext>
                  </a:extLst>
                </a:gridCol>
              </a:tblGrid>
              <a:tr h="17722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11382016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5747769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37971763"/>
                  </a:ext>
                </a:extLst>
              </a:tr>
            </a:tbl>
          </a:graphicData>
        </a:graphic>
      </p:graphicFrame>
      <p:sp>
        <p:nvSpPr>
          <p:cNvPr id="34" name="TextBox 33">
            <a:extLst>
              <a:ext uri="{FF2B5EF4-FFF2-40B4-BE49-F238E27FC236}">
                <a16:creationId xmlns:a16="http://schemas.microsoft.com/office/drawing/2014/main" id="{0E7FFEEA-C18E-5D17-418C-F2DB4F2504EB}"/>
              </a:ext>
            </a:extLst>
          </p:cNvPr>
          <p:cNvSpPr txBox="1"/>
          <p:nvPr/>
        </p:nvSpPr>
        <p:spPr>
          <a:xfrm>
            <a:off x="6656818" y="1369369"/>
            <a:ext cx="20313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CHX 50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g/ml		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A0919B70-45AD-DB8F-0955-7A9E9526AE17}"/>
              </a:ext>
            </a:extLst>
          </p:cNvPr>
          <p:cNvSpPr txBox="1"/>
          <p:nvPr/>
        </p:nvSpPr>
        <p:spPr>
          <a:xfrm>
            <a:off x="6391031" y="1700074"/>
            <a:ext cx="29546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MG132 20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g/ml		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9BBE111E-AC6D-EBE7-CA16-FFED6881F6C4}"/>
              </a:ext>
            </a:extLst>
          </p:cNvPr>
          <p:cNvSpPr txBox="1"/>
          <p:nvPr/>
        </p:nvSpPr>
        <p:spPr>
          <a:xfrm>
            <a:off x="6344139" y="2025527"/>
            <a:ext cx="29546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Baf-A1 0.2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g/ml		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E298E92C-4256-3E8D-473A-912A06C04186}"/>
              </a:ext>
            </a:extLst>
          </p:cNvPr>
          <p:cNvCxnSpPr>
            <a:cxnSpLocks/>
          </p:cNvCxnSpPr>
          <p:nvPr/>
        </p:nvCxnSpPr>
        <p:spPr>
          <a:xfrm>
            <a:off x="7216142" y="1273827"/>
            <a:ext cx="387716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Rectangle 37">
            <a:extLst>
              <a:ext uri="{FF2B5EF4-FFF2-40B4-BE49-F238E27FC236}">
                <a16:creationId xmlns:a16="http://schemas.microsoft.com/office/drawing/2014/main" id="{204AB03E-55E6-AA57-B19B-08422DCC9986}"/>
              </a:ext>
            </a:extLst>
          </p:cNvPr>
          <p:cNvSpPr/>
          <p:nvPr/>
        </p:nvSpPr>
        <p:spPr>
          <a:xfrm>
            <a:off x="9427576" y="911422"/>
            <a:ext cx="76723" cy="88229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F0789204-8043-C646-F3C3-5CE3F048B6D2}"/>
              </a:ext>
            </a:extLst>
          </p:cNvPr>
          <p:cNvSpPr/>
          <p:nvPr/>
        </p:nvSpPr>
        <p:spPr>
          <a:xfrm>
            <a:off x="10729296" y="924455"/>
            <a:ext cx="76723" cy="88229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2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CA8252E5-6A18-12EE-8304-2AD0021BCEF2}"/>
              </a:ext>
            </a:extLst>
          </p:cNvPr>
          <p:cNvSpPr txBox="1"/>
          <p:nvPr/>
        </p:nvSpPr>
        <p:spPr>
          <a:xfrm>
            <a:off x="10753758" y="1680738"/>
            <a:ext cx="6527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3hours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09C1842A-8364-ACF0-8D8C-66545CCD9929}"/>
              </a:ext>
            </a:extLst>
          </p:cNvPr>
          <p:cNvSpPr txBox="1"/>
          <p:nvPr/>
        </p:nvSpPr>
        <p:spPr>
          <a:xfrm>
            <a:off x="10753758" y="2040791"/>
            <a:ext cx="6527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3hours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6F069A1C-B262-C42A-2600-C62244D4F01F}"/>
              </a:ext>
            </a:extLst>
          </p:cNvPr>
          <p:cNvSpPr txBox="1"/>
          <p:nvPr/>
        </p:nvSpPr>
        <p:spPr>
          <a:xfrm>
            <a:off x="10758197" y="1343713"/>
            <a:ext cx="6527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dirty="0">
                <a:latin typeface="Arial" panose="020B0604020202020204" pitchFamily="34" charset="0"/>
                <a:cs typeface="Arial" panose="020B0604020202020204" pitchFamily="34" charset="0"/>
              </a:rPr>
              <a:t>3hours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D92BCD6D-A2B2-3F41-0245-87B78AC08E75}"/>
              </a:ext>
            </a:extLst>
          </p:cNvPr>
          <p:cNvSpPr/>
          <p:nvPr/>
        </p:nvSpPr>
        <p:spPr>
          <a:xfrm>
            <a:off x="6810998" y="887968"/>
            <a:ext cx="179288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Dox (µg/ml)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44DDC4EC-DD5B-FC2B-9359-73243EBBC522}"/>
              </a:ext>
            </a:extLst>
          </p:cNvPr>
          <p:cNvSpPr txBox="1"/>
          <p:nvPr/>
        </p:nvSpPr>
        <p:spPr>
          <a:xfrm>
            <a:off x="6804221" y="562515"/>
            <a:ext cx="104952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MITF</a:t>
            </a:r>
            <a:endParaRPr lang="en-GB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CAF09E34-F759-0335-3C6E-82246A6C82AC}"/>
              </a:ext>
            </a:extLst>
          </p:cNvPr>
          <p:cNvSpPr txBox="1"/>
          <p:nvPr/>
        </p:nvSpPr>
        <p:spPr>
          <a:xfrm>
            <a:off x="7875550" y="602677"/>
            <a:ext cx="383441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EV          WT             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                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0FFDFCB6-2EA3-2840-D7F1-3EF81D3DE140}"/>
              </a:ext>
            </a:extLst>
          </p:cNvPr>
          <p:cNvSpPr txBox="1"/>
          <p:nvPr/>
        </p:nvSpPr>
        <p:spPr>
          <a:xfrm>
            <a:off x="6537002" y="2772946"/>
            <a:ext cx="13840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99EDDF9C-7092-A2D6-F2B0-9EC76EAC8F0C}"/>
              </a:ext>
            </a:extLst>
          </p:cNvPr>
          <p:cNvSpPr txBox="1"/>
          <p:nvPr/>
        </p:nvSpPr>
        <p:spPr>
          <a:xfrm>
            <a:off x="6642332" y="3231921"/>
            <a:ext cx="12077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7BB38FB3-15FB-DC54-7634-201B906F0169}"/>
              </a:ext>
            </a:extLst>
          </p:cNvPr>
          <p:cNvSpPr txBox="1"/>
          <p:nvPr/>
        </p:nvSpPr>
        <p:spPr>
          <a:xfrm>
            <a:off x="6675716" y="3581528"/>
            <a:ext cx="11409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E0B51EE7-7C9E-02F0-2D1E-B02EC0EB2157}"/>
              </a:ext>
            </a:extLst>
          </p:cNvPr>
          <p:cNvSpPr txBox="1"/>
          <p:nvPr/>
        </p:nvSpPr>
        <p:spPr>
          <a:xfrm>
            <a:off x="9960763" y="4057092"/>
            <a:ext cx="723275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TF</a:t>
            </a:r>
            <a:endParaRPr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44166CD8-3BA2-53E1-7A7F-8CB22F40D746}"/>
              </a:ext>
            </a:extLst>
          </p:cNvPr>
          <p:cNvSpPr/>
          <p:nvPr/>
        </p:nvSpPr>
        <p:spPr>
          <a:xfrm>
            <a:off x="8147296" y="2985561"/>
            <a:ext cx="2424062" cy="852885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25727408-E13D-7551-8240-4C8A724BB8A8}"/>
              </a:ext>
            </a:extLst>
          </p:cNvPr>
          <p:cNvSpPr txBox="1"/>
          <p:nvPr/>
        </p:nvSpPr>
        <p:spPr>
          <a:xfrm>
            <a:off x="6628916" y="3901606"/>
            <a:ext cx="11409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68B9EC2E-33A0-2CE5-0BDD-201D21C4012E}"/>
              </a:ext>
            </a:extLst>
          </p:cNvPr>
          <p:cNvSpPr txBox="1"/>
          <p:nvPr/>
        </p:nvSpPr>
        <p:spPr>
          <a:xfrm>
            <a:off x="6560404" y="2498637"/>
            <a:ext cx="13840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19AE05A6-EDAF-D5CF-27A6-377B82B3F30E}"/>
              </a:ext>
            </a:extLst>
          </p:cNvPr>
          <p:cNvSpPr txBox="1"/>
          <p:nvPr/>
        </p:nvSpPr>
        <p:spPr>
          <a:xfrm>
            <a:off x="6560405" y="2248263"/>
            <a:ext cx="13840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4" name="Table 37">
            <a:extLst>
              <a:ext uri="{FF2B5EF4-FFF2-40B4-BE49-F238E27FC236}">
                <a16:creationId xmlns:a16="http://schemas.microsoft.com/office/drawing/2014/main" id="{A090A646-A007-A3C9-4C3A-DD904F3EF20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58853524"/>
              </p:ext>
            </p:extLst>
          </p:nvPr>
        </p:nvGraphicFramePr>
        <p:xfrm>
          <a:off x="8337539" y="1365601"/>
          <a:ext cx="797238" cy="10058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29132">
                  <a:extLst>
                    <a:ext uri="{9D8B030D-6E8A-4147-A177-3AD203B41FA5}">
                      <a16:colId xmlns:a16="http://schemas.microsoft.com/office/drawing/2014/main" val="2196274505"/>
                    </a:ext>
                  </a:extLst>
                </a:gridCol>
                <a:gridCol w="284053">
                  <a:extLst>
                    <a:ext uri="{9D8B030D-6E8A-4147-A177-3AD203B41FA5}">
                      <a16:colId xmlns:a16="http://schemas.microsoft.com/office/drawing/2014/main" val="2410484320"/>
                    </a:ext>
                  </a:extLst>
                </a:gridCol>
                <a:gridCol w="284053">
                  <a:extLst>
                    <a:ext uri="{9D8B030D-6E8A-4147-A177-3AD203B41FA5}">
                      <a16:colId xmlns:a16="http://schemas.microsoft.com/office/drawing/2014/main" val="2310628921"/>
                    </a:ext>
                  </a:extLst>
                </a:gridCol>
              </a:tblGrid>
              <a:tr h="17722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11382016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5747769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37971763"/>
                  </a:ext>
                </a:extLst>
              </a:tr>
            </a:tbl>
          </a:graphicData>
        </a:graphic>
      </p:graphicFrame>
      <p:graphicFrame>
        <p:nvGraphicFramePr>
          <p:cNvPr id="55" name="Table 37">
            <a:extLst>
              <a:ext uri="{FF2B5EF4-FFF2-40B4-BE49-F238E27FC236}">
                <a16:creationId xmlns:a16="http://schemas.microsoft.com/office/drawing/2014/main" id="{A4EF6244-F0ED-755E-937C-9C7C4728653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1613714"/>
              </p:ext>
            </p:extLst>
          </p:nvPr>
        </p:nvGraphicFramePr>
        <p:xfrm>
          <a:off x="9171619" y="1356134"/>
          <a:ext cx="797238" cy="10058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29132">
                  <a:extLst>
                    <a:ext uri="{9D8B030D-6E8A-4147-A177-3AD203B41FA5}">
                      <a16:colId xmlns:a16="http://schemas.microsoft.com/office/drawing/2014/main" val="2196274505"/>
                    </a:ext>
                  </a:extLst>
                </a:gridCol>
                <a:gridCol w="284053">
                  <a:extLst>
                    <a:ext uri="{9D8B030D-6E8A-4147-A177-3AD203B41FA5}">
                      <a16:colId xmlns:a16="http://schemas.microsoft.com/office/drawing/2014/main" val="2410484320"/>
                    </a:ext>
                  </a:extLst>
                </a:gridCol>
                <a:gridCol w="284053">
                  <a:extLst>
                    <a:ext uri="{9D8B030D-6E8A-4147-A177-3AD203B41FA5}">
                      <a16:colId xmlns:a16="http://schemas.microsoft.com/office/drawing/2014/main" val="2310628921"/>
                    </a:ext>
                  </a:extLst>
                </a:gridCol>
              </a:tblGrid>
              <a:tr h="17722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11382016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5747769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37971763"/>
                  </a:ext>
                </a:extLst>
              </a:tr>
            </a:tbl>
          </a:graphicData>
        </a:graphic>
      </p:graphicFrame>
      <p:graphicFrame>
        <p:nvGraphicFramePr>
          <p:cNvPr id="56" name="Table 37">
            <a:extLst>
              <a:ext uri="{FF2B5EF4-FFF2-40B4-BE49-F238E27FC236}">
                <a16:creationId xmlns:a16="http://schemas.microsoft.com/office/drawing/2014/main" id="{641A430F-B6F8-10F5-3280-D911A8A87C4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17989162"/>
              </p:ext>
            </p:extLst>
          </p:nvPr>
        </p:nvGraphicFramePr>
        <p:xfrm>
          <a:off x="9973293" y="1345882"/>
          <a:ext cx="797238" cy="10058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29132">
                  <a:extLst>
                    <a:ext uri="{9D8B030D-6E8A-4147-A177-3AD203B41FA5}">
                      <a16:colId xmlns:a16="http://schemas.microsoft.com/office/drawing/2014/main" val="2196274505"/>
                    </a:ext>
                  </a:extLst>
                </a:gridCol>
                <a:gridCol w="284053">
                  <a:extLst>
                    <a:ext uri="{9D8B030D-6E8A-4147-A177-3AD203B41FA5}">
                      <a16:colId xmlns:a16="http://schemas.microsoft.com/office/drawing/2014/main" val="2410484320"/>
                    </a:ext>
                  </a:extLst>
                </a:gridCol>
                <a:gridCol w="284053">
                  <a:extLst>
                    <a:ext uri="{9D8B030D-6E8A-4147-A177-3AD203B41FA5}">
                      <a16:colId xmlns:a16="http://schemas.microsoft.com/office/drawing/2014/main" val="2310628921"/>
                    </a:ext>
                  </a:extLst>
                </a:gridCol>
              </a:tblGrid>
              <a:tr h="17722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11382016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5747769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37971763"/>
                  </a:ext>
                </a:extLst>
              </a:tr>
            </a:tbl>
          </a:graphicData>
        </a:graphic>
      </p:graphicFrame>
      <p:graphicFrame>
        <p:nvGraphicFramePr>
          <p:cNvPr id="57" name="Table 37">
            <a:extLst>
              <a:ext uri="{FF2B5EF4-FFF2-40B4-BE49-F238E27FC236}">
                <a16:creationId xmlns:a16="http://schemas.microsoft.com/office/drawing/2014/main" id="{D28B3B88-57F4-BC42-D0AD-5E95F7D0ED8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42678853"/>
              </p:ext>
            </p:extLst>
          </p:nvPr>
        </p:nvGraphicFramePr>
        <p:xfrm>
          <a:off x="7611518" y="1334646"/>
          <a:ext cx="797238" cy="10058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29132">
                  <a:extLst>
                    <a:ext uri="{9D8B030D-6E8A-4147-A177-3AD203B41FA5}">
                      <a16:colId xmlns:a16="http://schemas.microsoft.com/office/drawing/2014/main" val="2196274505"/>
                    </a:ext>
                  </a:extLst>
                </a:gridCol>
                <a:gridCol w="284053">
                  <a:extLst>
                    <a:ext uri="{9D8B030D-6E8A-4147-A177-3AD203B41FA5}">
                      <a16:colId xmlns:a16="http://schemas.microsoft.com/office/drawing/2014/main" val="2410484320"/>
                    </a:ext>
                  </a:extLst>
                </a:gridCol>
                <a:gridCol w="284053">
                  <a:extLst>
                    <a:ext uri="{9D8B030D-6E8A-4147-A177-3AD203B41FA5}">
                      <a16:colId xmlns:a16="http://schemas.microsoft.com/office/drawing/2014/main" val="2310628921"/>
                    </a:ext>
                  </a:extLst>
                </a:gridCol>
              </a:tblGrid>
              <a:tr h="17722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11382016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5747769"/>
                  </a:ext>
                </a:extLst>
              </a:tr>
              <a:tr h="271588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-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solidFill>
                            <a:schemeClr val="tx1"/>
                          </a:solidFill>
                        </a:rPr>
                        <a:t>+</a:t>
                      </a:r>
                      <a:endParaRPr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3797176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18716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527</Words>
  <Application>Microsoft Macintosh PowerPoint</Application>
  <PresentationFormat>Widescreen</PresentationFormat>
  <Paragraphs>320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hung Hong Vu - HI</dc:creator>
  <cp:lastModifiedBy>Nhung Hong Vu - HI</cp:lastModifiedBy>
  <cp:revision>1</cp:revision>
  <dcterms:created xsi:type="dcterms:W3CDTF">2024-05-16T16:23:01Z</dcterms:created>
  <dcterms:modified xsi:type="dcterms:W3CDTF">2024-05-16T16:36:35Z</dcterms:modified>
</cp:coreProperties>
</file>